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6.xml.rels" ContentType="application/vnd.openxmlformats-package.relationships+xml"/>
  <Override PartName="/ppt/slideLayouts/slideLayout29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</p:sldMasterIdLst>
  <p:notesMasterIdLst>
    <p:notesMasterId r:id="rId5"/>
  </p:notesMasterIdLst>
  <p:sldIdLst>
    <p:sldId id="256" r:id="rId6"/>
  </p:sldIdLst>
  <p:sldSz cx="9144000" cy="6858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4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PlaceHolder 2"/>
          <p:cNvSpPr>
            <a:spLocks noGrp="1"/>
          </p:cNvSpPr>
          <p:nvPr>
            <p:ph type="dt" idx="4"/>
          </p:nvPr>
        </p:nvSpPr>
        <p:spPr>
          <a:xfrm>
            <a:off x="5179680" y="-36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PlaceHolder 3"/>
          <p:cNvSpPr>
            <a:spLocks noGrp="1"/>
          </p:cNvSpPr>
          <p:nvPr>
            <p:ph type="sldImg"/>
          </p:nvPr>
        </p:nvSpPr>
        <p:spPr>
          <a:xfrm>
            <a:off x="2857320" y="514440"/>
            <a:ext cx="3429000" cy="25718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4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laceHolder 5"/>
          <p:cNvSpPr>
            <a:spLocks noGrp="1"/>
          </p:cNvSpPr>
          <p:nvPr>
            <p:ph type="ftr" idx="5"/>
          </p:nvPr>
        </p:nvSpPr>
        <p:spPr>
          <a:xfrm>
            <a:off x="-360" y="651312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PlaceHolder 6"/>
          <p:cNvSpPr>
            <a:spLocks noGrp="1"/>
          </p:cNvSpPr>
          <p:nvPr>
            <p:ph type="sldNum" idx="6"/>
          </p:nvPr>
        </p:nvSpPr>
        <p:spPr>
          <a:xfrm>
            <a:off x="5179680" y="651312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8DF8E3-DC9B-4186-B7AA-7915350F1753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7" name="Rectangle 7"/>
          <p:cNvSpPr/>
          <p:nvPr/>
        </p:nvSpPr>
        <p:spPr>
          <a:xfrm>
            <a:off x="5180040" y="6513480"/>
            <a:ext cx="39625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267CB3-3438-4DA5-AE20-685302D929FE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PlaceHolder 1"/>
          <p:cNvSpPr>
            <a:spLocks noGrp="1"/>
          </p:cNvSpPr>
          <p:nvPr>
            <p:ph type="sldImg"/>
          </p:nvPr>
        </p:nvSpPr>
        <p:spPr>
          <a:xfrm>
            <a:off x="2857680" y="514440"/>
            <a:ext cx="3429000" cy="2571840"/>
          </a:xfrm>
          <a:prstGeom prst="rect">
            <a:avLst/>
          </a:prstGeom>
          <a:ln w="0">
            <a:noFill/>
          </a:ln>
        </p:spPr>
      </p:sp>
      <p:sp>
        <p:nvSpPr>
          <p:cNvPr id="369" name="PlaceHolder 2"/>
          <p:cNvSpPr>
            <a:spLocks noGrp="1"/>
          </p:cNvSpPr>
          <p:nvPr>
            <p:ph type="body"/>
          </p:nvPr>
        </p:nvSpPr>
        <p:spPr>
          <a:xfrm>
            <a:off x="1523880" y="3200040"/>
            <a:ext cx="6096240" cy="308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Aft>
                <a:spcPts val="1199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53266"/>
                </a:solidFill>
                <a:uFillTx/>
                <a:latin typeface="Arial"/>
              </a:rPr>
              <a:t>The Trofile Assay</a:t>
            </a:r>
            <a:r>
              <a:rPr b="1" lang="en-US" sz="1200" spc="-1" strike="noStrike">
                <a:solidFill>
                  <a:srgbClr val="053266"/>
                </a:solidFill>
                <a:latin typeface="Arial"/>
              </a:rPr>
              <a:t>: Patient plasma virus is subjected to RT-PCR amplification of to obtain a broad representation of envelope (env) genes from patient virus populations. </a:t>
            </a:r>
            <a:r>
              <a:rPr b="1" i="1" lang="en-US" sz="1200" spc="-1" strike="noStrike">
                <a:solidFill>
                  <a:srgbClr val="053266"/>
                </a:solidFill>
                <a:latin typeface="Arial"/>
              </a:rPr>
              <a:t>env</a:t>
            </a:r>
            <a:r>
              <a:rPr b="1" lang="en-US" sz="1200" spc="-1" strike="noStrike">
                <a:solidFill>
                  <a:srgbClr val="053266"/>
                </a:solidFill>
                <a:latin typeface="Arial"/>
              </a:rPr>
              <a:t> amplification products are then inserted into “HIV </a:t>
            </a:r>
            <a:r>
              <a:rPr b="1" i="1" lang="en-US" sz="1200" spc="-1" strike="noStrike">
                <a:solidFill>
                  <a:srgbClr val="053266"/>
                </a:solidFill>
                <a:latin typeface="Arial"/>
              </a:rPr>
              <a:t>env</a:t>
            </a:r>
            <a:r>
              <a:rPr b="1" lang="en-US" sz="1200" spc="-1" strike="noStrike">
                <a:solidFill>
                  <a:srgbClr val="053266"/>
                </a:solidFill>
                <a:latin typeface="Arial"/>
              </a:rPr>
              <a:t> expression vectors” (A).  Patient HIV </a:t>
            </a:r>
            <a:r>
              <a:rPr b="1" i="1" lang="en-US" sz="1200" spc="-1" strike="noStrike">
                <a:solidFill>
                  <a:srgbClr val="053266"/>
                </a:solidFill>
                <a:latin typeface="Arial"/>
              </a:rPr>
              <a:t>env</a:t>
            </a:r>
            <a:r>
              <a:rPr b="1" lang="en-US" sz="1200" spc="-1" strike="noStrike">
                <a:solidFill>
                  <a:srgbClr val="053266"/>
                </a:solidFill>
                <a:latin typeface="Arial"/>
              </a:rPr>
              <a:t> expression vectors are co-transfected with an env deleted “HIV genomic vector” (B) containing a firefly luciferase reporter gene that is used to quantify viral infectivity. Co-transfection of HIV </a:t>
            </a:r>
            <a:r>
              <a:rPr b="1" i="1" lang="en-US" sz="1200" spc="-1" strike="noStrike">
                <a:solidFill>
                  <a:srgbClr val="053266"/>
                </a:solidFill>
                <a:latin typeface="Arial"/>
              </a:rPr>
              <a:t>env</a:t>
            </a:r>
            <a:r>
              <a:rPr b="1" lang="en-US" sz="1200" spc="-1" strike="noStrike">
                <a:solidFill>
                  <a:srgbClr val="053266"/>
                </a:solidFill>
                <a:latin typeface="Arial"/>
              </a:rPr>
              <a:t> expression vectors and HIV genomic vectors produces HIV-1 pseudoviruses (C) expressing the </a:t>
            </a:r>
            <a:r>
              <a:rPr b="1" i="1" lang="en-US" sz="1200" spc="-1" strike="noStrike">
                <a:solidFill>
                  <a:srgbClr val="053266"/>
                </a:solidFill>
                <a:latin typeface="Arial"/>
              </a:rPr>
              <a:t>env </a:t>
            </a:r>
            <a:r>
              <a:rPr b="1" lang="en-US" sz="1200" spc="-1" strike="noStrike">
                <a:solidFill>
                  <a:srgbClr val="053266"/>
                </a:solidFill>
                <a:latin typeface="Arial"/>
              </a:rPr>
              <a:t>proteins derived from patient virus env sequences. Coreceptor tropism is determined by measuring the ability of pseudovirus populations to efficiently infect target cells co-expressing CD4 and CXCR4 (D) or CCR5 (E) co-receptors.  Co-receptor mediated infectivity is quantified by measuring luciferase infectivity in the CD4/CCR5 and CD4/CXCR4 target cells (portrayed as yellow asterisks).  In the diagram above, both CXCR4+ and CCR5+ cells are infected by pseudoviruses using patient </a:t>
            </a:r>
            <a:r>
              <a:rPr b="1" i="1" lang="en-US" sz="1200" spc="-1" strike="noStrike">
                <a:solidFill>
                  <a:srgbClr val="053266"/>
                </a:solidFill>
                <a:latin typeface="Arial"/>
              </a:rPr>
              <a:t>env</a:t>
            </a:r>
            <a:r>
              <a:rPr b="1" lang="en-US" sz="1200" spc="-1" strike="noStrike">
                <a:solidFill>
                  <a:srgbClr val="053266"/>
                </a:solidFill>
                <a:latin typeface="Arial"/>
              </a:rPr>
              <a:t> and, therefore, viral tropism would be classified as “R5/X4” or “dual/mixed”. To confirm co-receptor usage, CCR5 and CXCR4 entry inhibitors are added to target cells (F). Viruses susceptible to CCR5 and/or CXCR4 antagonists do not produce luciferase in the corresponding target cells.  Envelope genes encoding envelope proteins capable of using the CXCR4 co-receptor, the CCR5 co-receptors, or both co-receptors are shown in green, red and blue, respectively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A9383D-FA97-4F7A-BB85-2A3F8AF6186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6B3111-929B-4DB2-8BCA-845E870B49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0DFFE7-7F76-497A-AD25-F39F4D2C36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45CF00-6236-4D42-A68F-AFBBF67DB6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AA51C4-E668-4FED-A728-2D19468E65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CF7F4D-5E01-4B7B-8CF8-77EC4FB885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3415D1-9075-42EC-B454-33F7C666AB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17E428-028F-4200-8E44-35F2286A8F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520E21-4F18-499C-B14C-725641A278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38466A-6847-41BF-A2D4-D13F13765D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C4EFC2-1604-4FDE-914D-8F05335A81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917E94-76B9-4371-B158-49886B0E607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25.xml"/><Relationship Id="rId4" Type="http://schemas.openxmlformats.org/officeDocument/2006/relationships/slideLayout" Target="../slideLayouts/slideLayout26.xml"/><Relationship Id="rId5" Type="http://schemas.openxmlformats.org/officeDocument/2006/relationships/slideLayout" Target="../slideLayouts/slideLayout27.xml"/><Relationship Id="rId6" Type="http://schemas.openxmlformats.org/officeDocument/2006/relationships/slideLayout" Target="../slideLayouts/slideLayout28.xml"/><Relationship Id="rId7" Type="http://schemas.openxmlformats.org/officeDocument/2006/relationships/slideLayout" Target="../slideLayouts/slideLayout29.xml"/><Relationship Id="rId8" Type="http://schemas.openxmlformats.org/officeDocument/2006/relationships/slideLayout" Target="../slideLayouts/slideLayout30.xml"/><Relationship Id="rId9" Type="http://schemas.openxmlformats.org/officeDocument/2006/relationships/slideLayout" Target="../slideLayouts/slideLayout31.xml"/><Relationship Id="rId10" Type="http://schemas.openxmlformats.org/officeDocument/2006/relationships/slideLayout" Target="../slideLayouts/slideLayout32.xml"/><Relationship Id="rId11" Type="http://schemas.openxmlformats.org/officeDocument/2006/relationships/slideLayout" Target="../slideLayouts/slideLayout33.xml"/><Relationship Id="rId12" Type="http://schemas.openxmlformats.org/officeDocument/2006/relationships/slideLayout" Target="../slideLayouts/slideLayout34.xml"/><Relationship Id="rId13" Type="http://schemas.openxmlformats.org/officeDocument/2006/relationships/slideLayout" Target="../slideLayouts/slideLayout35.xml"/><Relationship Id="rId14" Type="http://schemas.openxmlformats.org/officeDocument/2006/relationships/slideLayout" Target="../slideLayouts/slideLayout36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1f1f7b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Rectangle 2"/>
          <p:cNvSpPr/>
          <p:nvPr/>
        </p:nvSpPr>
        <p:spPr>
          <a:xfrm>
            <a:off x="0" y="0"/>
            <a:ext cx="9144000" cy="1244520"/>
          </a:xfrm>
          <a:prstGeom prst="rect">
            <a:avLst/>
          </a:prstGeom>
          <a:solidFill>
            <a:srgbClr val="7998c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1"/>
          <p:cNvSpPr>
            <a:spLocks noGrp="1"/>
          </p:cNvSpPr>
          <p:nvPr>
            <p:ph type="title"/>
          </p:nvPr>
        </p:nvSpPr>
        <p:spPr>
          <a:xfrm>
            <a:off x="457200" y="166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8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" name="Rectangle 4"/>
          <p:cNvSpPr/>
          <p:nvPr/>
        </p:nvSpPr>
        <p:spPr>
          <a:xfrm>
            <a:off x="0" y="1231920"/>
            <a:ext cx="9144000" cy="42840"/>
          </a:xfrm>
          <a:prstGeom prst="rect">
            <a:avLst/>
          </a:prstGeom>
          <a:solidFill>
            <a:srgbClr val="ff780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457200" y="1523520"/>
            <a:ext cx="8229600" cy="475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Aft>
                <a:spcPts val="876"/>
              </a:spcAft>
              <a:buClr>
                <a:srgbClr val="ff780a"/>
              </a:buClr>
              <a:buFont typeface="Symbol" charset="2"/>
              <a:buChar char="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spcAft>
                <a:spcPts val="876"/>
              </a:spcAft>
              <a:buClr>
                <a:srgbClr val="ff780a"/>
              </a:buClr>
              <a:buFont typeface="Helvetica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2" marL="1143000" indent="-228600">
              <a:spcAft>
                <a:spcPts val="876"/>
              </a:spcAft>
              <a:buClr>
                <a:srgbClr val="ff780a"/>
              </a:buClr>
              <a:buFont typeface="Tempus Sans ITC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3" marL="1600200" indent="-228600">
              <a:spcAft>
                <a:spcPts val="876"/>
              </a:spcAft>
              <a:buClr>
                <a:srgbClr val="ff780a"/>
              </a:buClr>
              <a:buFont typeface="Helvetica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4" marL="2057400" indent="-228600">
              <a:spcAft>
                <a:spcPts val="876"/>
              </a:spcAft>
              <a:buClr>
                <a:srgbClr val="ff780a"/>
              </a:buClr>
              <a:buFont typeface="Tempus Sans ITC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5" marL="2057400" indent="-228600">
              <a:spcAft>
                <a:spcPts val="876"/>
              </a:spcAft>
              <a:buClr>
                <a:srgbClr val="000000"/>
              </a:buClr>
              <a:buFont typeface="Tempus Sans ITC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6" marL="2057400" indent="-228600">
              <a:spcAft>
                <a:spcPts val="876"/>
              </a:spcAft>
              <a:buClr>
                <a:srgbClr val="000000"/>
              </a:buClr>
              <a:buFont typeface="Tempus Sans ITC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997EAE-4BF8-4C2D-A0E3-D60F17E1178E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1f1f7b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Picture 2" descr="CAB_GRND_SIGN_02"/>
          <p:cNvPicPr/>
          <p:nvPr/>
        </p:nvPicPr>
        <p:blipFill>
          <a:blip r:embed="rId2"/>
          <a:srcRect l="25794" t="28679" r="42196" b="2426"/>
          <a:stretch/>
        </p:blipFill>
        <p:spPr>
          <a:xfrm>
            <a:off x="-25560" y="0"/>
            <a:ext cx="9220320" cy="6858000"/>
          </a:xfrm>
          <a:prstGeom prst="rect">
            <a:avLst/>
          </a:prstGeom>
          <a:ln w="0">
            <a:noFill/>
          </a:ln>
        </p:spPr>
      </p:pic>
      <p:sp>
        <p:nvSpPr>
          <p:cNvPr id="82" name="Rectangle 3"/>
          <p:cNvSpPr/>
          <p:nvPr/>
        </p:nvSpPr>
        <p:spPr>
          <a:xfrm>
            <a:off x="-12600" y="2921040"/>
            <a:ext cx="9194760" cy="3936960"/>
          </a:xfrm>
          <a:prstGeom prst="rect">
            <a:avLst/>
          </a:prstGeom>
          <a:solidFill>
            <a:srgbClr val="3f619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457200" y="166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8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ffffff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 type="body"/>
          </p:nvPr>
        </p:nvSpPr>
        <p:spPr>
          <a:xfrm>
            <a:off x="457200" y="1523520"/>
            <a:ext cx="8229600" cy="475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Aft>
                <a:spcPts val="876"/>
              </a:spcAft>
              <a:buClr>
                <a:srgbClr val="ff780a"/>
              </a:buClr>
              <a:buFont typeface="Symbol" charset="2"/>
              <a:buChar char="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spcAft>
                <a:spcPts val="876"/>
              </a:spcAft>
              <a:buClr>
                <a:srgbClr val="ff780a"/>
              </a:buClr>
              <a:buFont typeface="Helvetica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2" marL="1143000" indent="-228600">
              <a:spcAft>
                <a:spcPts val="876"/>
              </a:spcAft>
              <a:buClr>
                <a:srgbClr val="ff780a"/>
              </a:buClr>
              <a:buFont typeface="Tempus Sans ITC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3" marL="1600200" indent="-228600">
              <a:spcAft>
                <a:spcPts val="876"/>
              </a:spcAft>
              <a:buClr>
                <a:srgbClr val="ff780a"/>
              </a:buClr>
              <a:buFont typeface="Helvetica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4" marL="2057400" indent="-228600">
              <a:spcAft>
                <a:spcPts val="876"/>
              </a:spcAft>
              <a:buClr>
                <a:srgbClr val="ff780a"/>
              </a:buClr>
              <a:buFont typeface="Tempus Sans ITC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5" marL="2057400" indent="-228600">
              <a:spcAft>
                <a:spcPts val="876"/>
              </a:spcAft>
              <a:buClr>
                <a:srgbClr val="000000"/>
              </a:buClr>
              <a:buFont typeface="Tempus Sans ITC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lvl="6" marL="2057400" indent="-228600">
              <a:spcAft>
                <a:spcPts val="876"/>
              </a:spcAft>
              <a:buClr>
                <a:srgbClr val="000000"/>
              </a:buClr>
              <a:buFont typeface="Tempus Sans ITC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  <p:sldLayoutId id="2147483685" r:id="rId13"/>
    <p:sldLayoutId id="2147483686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3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Text Box 2"/>
          <p:cNvSpPr/>
          <p:nvPr/>
        </p:nvSpPr>
        <p:spPr>
          <a:xfrm>
            <a:off x="-93600" y="5494320"/>
            <a:ext cx="923760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9" name="Group 241"/>
          <p:cNvGrpSpPr/>
          <p:nvPr/>
        </p:nvGrpSpPr>
        <p:grpSpPr>
          <a:xfrm>
            <a:off x="293400" y="-38160"/>
            <a:ext cx="8578080" cy="4619880"/>
            <a:chOff x="293400" y="-38160"/>
            <a:chExt cx="8578080" cy="4619880"/>
          </a:xfrm>
        </p:grpSpPr>
        <p:sp>
          <p:nvSpPr>
            <p:cNvPr id="130" name="Text Box 223"/>
            <p:cNvSpPr/>
            <p:nvPr/>
          </p:nvSpPr>
          <p:spPr>
            <a:xfrm>
              <a:off x="293400" y="442800"/>
              <a:ext cx="40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ff"/>
                  </a:solidFill>
                  <a:latin typeface="Arial"/>
                </a:rPr>
                <a:t>B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1" name="Group 240"/>
            <p:cNvGrpSpPr/>
            <p:nvPr/>
          </p:nvGrpSpPr>
          <p:grpSpPr>
            <a:xfrm>
              <a:off x="369000" y="-38160"/>
              <a:ext cx="8502480" cy="4619880"/>
              <a:chOff x="369000" y="-38160"/>
              <a:chExt cx="8502480" cy="4619880"/>
            </a:xfrm>
          </p:grpSpPr>
          <p:sp>
            <p:nvSpPr>
              <p:cNvPr id="132" name="Text Box 224"/>
              <p:cNvSpPr/>
              <p:nvPr/>
            </p:nvSpPr>
            <p:spPr>
              <a:xfrm>
                <a:off x="1934640" y="-38160"/>
                <a:ext cx="4093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ff"/>
                    </a:solidFill>
                    <a:latin typeface="Arial"/>
                  </a:rPr>
                  <a:t>A.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33" name="Group 239"/>
              <p:cNvGrpSpPr/>
              <p:nvPr/>
            </p:nvGrpSpPr>
            <p:grpSpPr>
              <a:xfrm>
                <a:off x="369000" y="153720"/>
                <a:ext cx="8502480" cy="4428000"/>
                <a:chOff x="369000" y="153720"/>
                <a:chExt cx="8502480" cy="4428000"/>
              </a:xfrm>
            </p:grpSpPr>
            <p:grpSp>
              <p:nvGrpSpPr>
                <p:cNvPr id="134" name="Group 229"/>
                <p:cNvGrpSpPr/>
                <p:nvPr/>
              </p:nvGrpSpPr>
              <p:grpSpPr>
                <a:xfrm>
                  <a:off x="5432400" y="261360"/>
                  <a:ext cx="2558520" cy="1887480"/>
                  <a:chOff x="5432400" y="261360"/>
                  <a:chExt cx="2558520" cy="1887480"/>
                </a:xfrm>
              </p:grpSpPr>
              <p:sp>
                <p:nvSpPr>
                  <p:cNvPr id="135" name="Freeform 111"/>
                  <p:cNvSpPr/>
                  <p:nvPr/>
                </p:nvSpPr>
                <p:spPr>
                  <a:xfrm>
                    <a:off x="5466960" y="261360"/>
                    <a:ext cx="2523960" cy="1887480"/>
                  </a:xfrm>
                  <a:custGeom>
                    <a:avLst/>
                    <a:gdLst>
                      <a:gd name="textAreaLeft" fmla="*/ 0 w 2523960"/>
                      <a:gd name="textAreaRight" fmla="*/ 2524320 w 2523960"/>
                      <a:gd name="textAreaTop" fmla="*/ 0 h 1887480"/>
                      <a:gd name="textAreaBottom" fmla="*/ 1887840 h 1887480"/>
                    </a:gdLst>
                    <a:ahLst/>
                    <a:rect l="textAreaLeft" t="textAreaTop" r="textAreaRight" b="textAreaBottom"/>
                    <a:pathLst>
                      <a:path w="1761" h="1317">
                        <a:moveTo>
                          <a:pt x="169" y="727"/>
                        </a:moveTo>
                        <a:lnTo>
                          <a:pt x="203" y="717"/>
                        </a:lnTo>
                        <a:lnTo>
                          <a:pt x="235" y="700"/>
                        </a:lnTo>
                        <a:lnTo>
                          <a:pt x="300" y="682"/>
                        </a:lnTo>
                        <a:lnTo>
                          <a:pt x="365" y="665"/>
                        </a:lnTo>
                        <a:lnTo>
                          <a:pt x="430" y="629"/>
                        </a:lnTo>
                        <a:lnTo>
                          <a:pt x="495" y="594"/>
                        </a:lnTo>
                        <a:lnTo>
                          <a:pt x="543" y="559"/>
                        </a:lnTo>
                        <a:lnTo>
                          <a:pt x="597" y="515"/>
                        </a:lnTo>
                        <a:lnTo>
                          <a:pt x="641" y="471"/>
                        </a:lnTo>
                        <a:lnTo>
                          <a:pt x="669" y="453"/>
                        </a:lnTo>
                        <a:lnTo>
                          <a:pt x="706" y="418"/>
                        </a:lnTo>
                        <a:lnTo>
                          <a:pt x="738" y="383"/>
                        </a:lnTo>
                        <a:lnTo>
                          <a:pt x="771" y="348"/>
                        </a:lnTo>
                        <a:lnTo>
                          <a:pt x="835" y="295"/>
                        </a:lnTo>
                        <a:lnTo>
                          <a:pt x="880" y="260"/>
                        </a:lnTo>
                        <a:lnTo>
                          <a:pt x="916" y="224"/>
                        </a:lnTo>
                        <a:lnTo>
                          <a:pt x="970" y="183"/>
                        </a:lnTo>
                        <a:lnTo>
                          <a:pt x="1014" y="154"/>
                        </a:lnTo>
                        <a:lnTo>
                          <a:pt x="1049" y="134"/>
                        </a:lnTo>
                        <a:lnTo>
                          <a:pt x="1090" y="103"/>
                        </a:lnTo>
                        <a:lnTo>
                          <a:pt x="1127" y="84"/>
                        </a:lnTo>
                        <a:lnTo>
                          <a:pt x="1175" y="52"/>
                        </a:lnTo>
                        <a:lnTo>
                          <a:pt x="1246" y="24"/>
                        </a:lnTo>
                        <a:lnTo>
                          <a:pt x="1290" y="13"/>
                        </a:lnTo>
                        <a:lnTo>
                          <a:pt x="1348" y="0"/>
                        </a:lnTo>
                        <a:lnTo>
                          <a:pt x="1381" y="0"/>
                        </a:lnTo>
                        <a:lnTo>
                          <a:pt x="1417" y="0"/>
                        </a:lnTo>
                        <a:lnTo>
                          <a:pt x="1461" y="9"/>
                        </a:lnTo>
                        <a:lnTo>
                          <a:pt x="1516" y="20"/>
                        </a:lnTo>
                        <a:lnTo>
                          <a:pt x="1561" y="35"/>
                        </a:lnTo>
                        <a:lnTo>
                          <a:pt x="1611" y="56"/>
                        </a:lnTo>
                        <a:lnTo>
                          <a:pt x="1663" y="101"/>
                        </a:lnTo>
                        <a:lnTo>
                          <a:pt x="1695" y="136"/>
                        </a:lnTo>
                        <a:lnTo>
                          <a:pt x="1725" y="180"/>
                        </a:lnTo>
                        <a:lnTo>
                          <a:pt x="1744" y="242"/>
                        </a:lnTo>
                        <a:lnTo>
                          <a:pt x="1760" y="312"/>
                        </a:lnTo>
                        <a:lnTo>
                          <a:pt x="1760" y="348"/>
                        </a:lnTo>
                        <a:lnTo>
                          <a:pt x="1760" y="383"/>
                        </a:lnTo>
                        <a:lnTo>
                          <a:pt x="1760" y="418"/>
                        </a:lnTo>
                        <a:lnTo>
                          <a:pt x="1760" y="489"/>
                        </a:lnTo>
                        <a:lnTo>
                          <a:pt x="1756" y="541"/>
                        </a:lnTo>
                        <a:lnTo>
                          <a:pt x="1744" y="612"/>
                        </a:lnTo>
                        <a:lnTo>
                          <a:pt x="1736" y="651"/>
                        </a:lnTo>
                        <a:lnTo>
                          <a:pt x="1720" y="713"/>
                        </a:lnTo>
                        <a:lnTo>
                          <a:pt x="1708" y="757"/>
                        </a:lnTo>
                        <a:lnTo>
                          <a:pt x="1691" y="797"/>
                        </a:lnTo>
                        <a:lnTo>
                          <a:pt x="1675" y="840"/>
                        </a:lnTo>
                        <a:lnTo>
                          <a:pt x="1646" y="893"/>
                        </a:lnTo>
                        <a:lnTo>
                          <a:pt x="1630" y="929"/>
                        </a:lnTo>
                        <a:lnTo>
                          <a:pt x="1614" y="964"/>
                        </a:lnTo>
                        <a:lnTo>
                          <a:pt x="1582" y="1017"/>
                        </a:lnTo>
                        <a:lnTo>
                          <a:pt x="1533" y="1070"/>
                        </a:lnTo>
                        <a:lnTo>
                          <a:pt x="1500" y="1105"/>
                        </a:lnTo>
                        <a:lnTo>
                          <a:pt x="1468" y="1140"/>
                        </a:lnTo>
                        <a:lnTo>
                          <a:pt x="1419" y="1175"/>
                        </a:lnTo>
                        <a:lnTo>
                          <a:pt x="1394" y="1188"/>
                        </a:lnTo>
                        <a:lnTo>
                          <a:pt x="1358" y="1202"/>
                        </a:lnTo>
                        <a:lnTo>
                          <a:pt x="1314" y="1219"/>
                        </a:lnTo>
                        <a:lnTo>
                          <a:pt x="1225" y="1246"/>
                        </a:lnTo>
                        <a:lnTo>
                          <a:pt x="1160" y="1263"/>
                        </a:lnTo>
                        <a:lnTo>
                          <a:pt x="1111" y="1281"/>
                        </a:lnTo>
                        <a:lnTo>
                          <a:pt x="1048" y="1288"/>
                        </a:lnTo>
                        <a:lnTo>
                          <a:pt x="998" y="1298"/>
                        </a:lnTo>
                        <a:lnTo>
                          <a:pt x="949" y="1298"/>
                        </a:lnTo>
                        <a:lnTo>
                          <a:pt x="892" y="1307"/>
                        </a:lnTo>
                        <a:lnTo>
                          <a:pt x="832" y="1307"/>
                        </a:lnTo>
                        <a:lnTo>
                          <a:pt x="771" y="1316"/>
                        </a:lnTo>
                        <a:lnTo>
                          <a:pt x="722" y="1316"/>
                        </a:lnTo>
                        <a:lnTo>
                          <a:pt x="689" y="1316"/>
                        </a:lnTo>
                        <a:lnTo>
                          <a:pt x="608" y="1316"/>
                        </a:lnTo>
                        <a:lnTo>
                          <a:pt x="560" y="1316"/>
                        </a:lnTo>
                        <a:lnTo>
                          <a:pt x="479" y="1316"/>
                        </a:lnTo>
                        <a:lnTo>
                          <a:pt x="430" y="1316"/>
                        </a:lnTo>
                        <a:lnTo>
                          <a:pt x="386" y="1312"/>
                        </a:lnTo>
                        <a:lnTo>
                          <a:pt x="310" y="1294"/>
                        </a:lnTo>
                        <a:lnTo>
                          <a:pt x="284" y="1281"/>
                        </a:lnTo>
                        <a:lnTo>
                          <a:pt x="235" y="1259"/>
                        </a:lnTo>
                        <a:lnTo>
                          <a:pt x="207" y="1241"/>
                        </a:lnTo>
                        <a:lnTo>
                          <a:pt x="170" y="1210"/>
                        </a:lnTo>
                        <a:lnTo>
                          <a:pt x="139" y="1184"/>
                        </a:lnTo>
                        <a:lnTo>
                          <a:pt x="89" y="1140"/>
                        </a:lnTo>
                        <a:lnTo>
                          <a:pt x="57" y="1105"/>
                        </a:lnTo>
                        <a:lnTo>
                          <a:pt x="31" y="1074"/>
                        </a:lnTo>
                        <a:lnTo>
                          <a:pt x="16" y="1043"/>
                        </a:lnTo>
                        <a:lnTo>
                          <a:pt x="0" y="996"/>
                        </a:lnTo>
                        <a:lnTo>
                          <a:pt x="0" y="959"/>
                        </a:lnTo>
                        <a:lnTo>
                          <a:pt x="12" y="911"/>
                        </a:lnTo>
                        <a:lnTo>
                          <a:pt x="24" y="876"/>
                        </a:lnTo>
                        <a:lnTo>
                          <a:pt x="41" y="841"/>
                        </a:lnTo>
                        <a:lnTo>
                          <a:pt x="64" y="814"/>
                        </a:lnTo>
                        <a:lnTo>
                          <a:pt x="89" y="788"/>
                        </a:lnTo>
                        <a:lnTo>
                          <a:pt x="122" y="753"/>
                        </a:lnTo>
                        <a:lnTo>
                          <a:pt x="154" y="735"/>
                        </a:lnTo>
                        <a:lnTo>
                          <a:pt x="157" y="741"/>
                        </a:lnTo>
                        <a:lnTo>
                          <a:pt x="169" y="727"/>
                        </a:lnTo>
                      </a:path>
                    </a:pathLst>
                  </a:custGeom>
                  <a:blipFill rotWithShape="0">
                    <a:blip r:embed="rId1"/>
                    <a:srcRect/>
                    <a:stretch/>
                  </a:blipFill>
                  <a:ln cap="rnd"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" name="Oval 112"/>
                  <p:cNvSpPr/>
                  <p:nvPr/>
                </p:nvSpPr>
                <p:spPr>
                  <a:xfrm>
                    <a:off x="5621040" y="1756800"/>
                    <a:ext cx="58320" cy="5868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5400" bIns="-54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" name="Oval 113"/>
                  <p:cNvSpPr/>
                  <p:nvPr/>
                </p:nvSpPr>
                <p:spPr>
                  <a:xfrm rot="19680000">
                    <a:off x="6449760" y="1240560"/>
                    <a:ext cx="1248840" cy="601560"/>
                  </a:xfrm>
                  <a:prstGeom prst="ellipse">
                    <a:avLst/>
                  </a:prstGeom>
                  <a:gradFill rotWithShape="0">
                    <a:gsLst>
                      <a:gs pos="0">
                        <a:srgbClr val="cc99ff"/>
                      </a:gs>
                      <a:gs pos="100000">
                        <a:srgbClr val="5e4776"/>
                      </a:gs>
                    </a:gsLst>
                    <a:path path="rect">
                      <a:fillToRect l="50000" t="50000" r="50000" b="50000"/>
                    </a:path>
                  </a:gradFill>
                  <a:ln w="19080">
                    <a:solidFill>
                      <a:srgbClr val="bbe0e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" name="Oval 114"/>
                  <p:cNvSpPr/>
                  <p:nvPr/>
                </p:nvSpPr>
                <p:spPr>
                  <a:xfrm>
                    <a:off x="6322680" y="1434600"/>
                    <a:ext cx="131400" cy="115920"/>
                  </a:xfrm>
                  <a:prstGeom prst="ellipse">
                    <a:avLst/>
                  </a:prstGeom>
                  <a:solidFill>
                    <a:srgbClr val="fafd00"/>
                  </a:solidFill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35280" bIns="352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9" name="Line 115"/>
                  <p:cNvSpPr/>
                  <p:nvPr/>
                </p:nvSpPr>
                <p:spPr>
                  <a:xfrm>
                    <a:off x="6387840" y="1310760"/>
                    <a:ext cx="0" cy="1252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0" name="Line 116"/>
                  <p:cNvSpPr/>
                  <p:nvPr/>
                </p:nvSpPr>
                <p:spPr>
                  <a:xfrm>
                    <a:off x="6387840" y="1556640"/>
                    <a:ext cx="0" cy="12564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1" name="Line 117"/>
                  <p:cNvSpPr/>
                  <p:nvPr/>
                </p:nvSpPr>
                <p:spPr>
                  <a:xfrm flipH="1">
                    <a:off x="6448320" y="1496520"/>
                    <a:ext cx="151920" cy="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2" name="Line 118"/>
                  <p:cNvSpPr/>
                  <p:nvPr/>
                </p:nvSpPr>
                <p:spPr>
                  <a:xfrm flipH="1">
                    <a:off x="6181200" y="1493280"/>
                    <a:ext cx="147240" cy="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3" name="Line 119"/>
                  <p:cNvSpPr/>
                  <p:nvPr/>
                </p:nvSpPr>
                <p:spPr>
                  <a:xfrm flipH="1">
                    <a:off x="6432480" y="1359720"/>
                    <a:ext cx="115200" cy="9072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920" bIns="439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4" name="Line 120"/>
                  <p:cNvSpPr/>
                  <p:nvPr/>
                </p:nvSpPr>
                <p:spPr>
                  <a:xfrm flipH="1">
                    <a:off x="6233760" y="1534320"/>
                    <a:ext cx="110880" cy="874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0680" bIns="406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5" name="Line 121"/>
                  <p:cNvSpPr/>
                  <p:nvPr/>
                </p:nvSpPr>
                <p:spPr>
                  <a:xfrm flipH="1" flipV="1">
                    <a:off x="6224400" y="1340280"/>
                    <a:ext cx="121680" cy="11916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6" name="Line 122"/>
                  <p:cNvSpPr/>
                  <p:nvPr/>
                </p:nvSpPr>
                <p:spPr>
                  <a:xfrm flipH="1" flipV="1">
                    <a:off x="6427440" y="1526040"/>
                    <a:ext cx="109440" cy="1126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7" name="Oval 123"/>
                  <p:cNvSpPr/>
                  <p:nvPr/>
                </p:nvSpPr>
                <p:spPr>
                  <a:xfrm>
                    <a:off x="5989320" y="1388520"/>
                    <a:ext cx="131400" cy="11592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12600">
                    <a:solidFill>
                      <a:srgbClr val="ffff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35280" bIns="352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8" name="Line 124"/>
                  <p:cNvSpPr/>
                  <p:nvPr/>
                </p:nvSpPr>
                <p:spPr>
                  <a:xfrm>
                    <a:off x="6055920" y="1264680"/>
                    <a:ext cx="0" cy="125280"/>
                  </a:xfrm>
                  <a:prstGeom prst="line">
                    <a:avLst/>
                  </a:prstGeom>
                  <a:ln w="12600">
                    <a:solidFill>
                      <a:srgbClr val="ffff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9" name="Line 125"/>
                  <p:cNvSpPr/>
                  <p:nvPr/>
                </p:nvSpPr>
                <p:spPr>
                  <a:xfrm>
                    <a:off x="6055920" y="1510560"/>
                    <a:ext cx="0" cy="127080"/>
                  </a:xfrm>
                  <a:prstGeom prst="line">
                    <a:avLst/>
                  </a:prstGeom>
                  <a:ln w="12600">
                    <a:solidFill>
                      <a:srgbClr val="ffff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0" name="Line 126"/>
                  <p:cNvSpPr/>
                  <p:nvPr/>
                </p:nvSpPr>
                <p:spPr>
                  <a:xfrm flipH="1">
                    <a:off x="6116400" y="1450440"/>
                    <a:ext cx="151920" cy="0"/>
                  </a:xfrm>
                  <a:prstGeom prst="line">
                    <a:avLst/>
                  </a:prstGeom>
                  <a:ln w="12600">
                    <a:solidFill>
                      <a:srgbClr val="ffff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1" name="Line 127"/>
                  <p:cNvSpPr/>
                  <p:nvPr/>
                </p:nvSpPr>
                <p:spPr>
                  <a:xfrm flipH="1">
                    <a:off x="5847840" y="1447200"/>
                    <a:ext cx="148680" cy="0"/>
                  </a:xfrm>
                  <a:prstGeom prst="line">
                    <a:avLst/>
                  </a:prstGeom>
                  <a:ln w="12600">
                    <a:solidFill>
                      <a:srgbClr val="ffff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2" name="Line 128"/>
                  <p:cNvSpPr/>
                  <p:nvPr/>
                </p:nvSpPr>
                <p:spPr>
                  <a:xfrm flipH="1">
                    <a:off x="6098400" y="1314000"/>
                    <a:ext cx="115560" cy="90360"/>
                  </a:xfrm>
                  <a:prstGeom prst="line">
                    <a:avLst/>
                  </a:prstGeom>
                  <a:ln w="12600">
                    <a:solidFill>
                      <a:srgbClr val="ffff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560" bIns="435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3" name="Line 129"/>
                  <p:cNvSpPr/>
                  <p:nvPr/>
                </p:nvSpPr>
                <p:spPr>
                  <a:xfrm flipH="1">
                    <a:off x="5900400" y="1490040"/>
                    <a:ext cx="112320" cy="85680"/>
                  </a:xfrm>
                  <a:prstGeom prst="line">
                    <a:avLst/>
                  </a:prstGeom>
                  <a:ln w="12600">
                    <a:solidFill>
                      <a:srgbClr val="ffff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8880" bIns="388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4" name="Line 130"/>
                  <p:cNvSpPr/>
                  <p:nvPr/>
                </p:nvSpPr>
                <p:spPr>
                  <a:xfrm flipH="1" flipV="1">
                    <a:off x="5890680" y="1294920"/>
                    <a:ext cx="123480" cy="118800"/>
                  </a:xfrm>
                  <a:prstGeom prst="line">
                    <a:avLst/>
                  </a:prstGeom>
                  <a:ln w="12600">
                    <a:solidFill>
                      <a:srgbClr val="ffff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5" name="Line 131"/>
                  <p:cNvSpPr/>
                  <p:nvPr/>
                </p:nvSpPr>
                <p:spPr>
                  <a:xfrm flipH="1" flipV="1">
                    <a:off x="6094080" y="1480320"/>
                    <a:ext cx="110880" cy="112680"/>
                  </a:xfrm>
                  <a:prstGeom prst="line">
                    <a:avLst/>
                  </a:prstGeom>
                  <a:ln w="12600">
                    <a:solidFill>
                      <a:srgbClr val="ffff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6" name="Oval 132"/>
                  <p:cNvSpPr/>
                  <p:nvPr/>
                </p:nvSpPr>
                <p:spPr>
                  <a:xfrm>
                    <a:off x="7670520" y="1032840"/>
                    <a:ext cx="131400" cy="115920"/>
                  </a:xfrm>
                  <a:prstGeom prst="ellipse">
                    <a:avLst/>
                  </a:prstGeom>
                  <a:solidFill>
                    <a:srgbClr val="fafd00"/>
                  </a:solidFill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35280" bIns="352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7" name="Line 133"/>
                  <p:cNvSpPr/>
                  <p:nvPr/>
                </p:nvSpPr>
                <p:spPr>
                  <a:xfrm>
                    <a:off x="7735680" y="909000"/>
                    <a:ext cx="0" cy="1252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8" name="Line 134"/>
                  <p:cNvSpPr/>
                  <p:nvPr/>
                </p:nvSpPr>
                <p:spPr>
                  <a:xfrm>
                    <a:off x="7735680" y="1155240"/>
                    <a:ext cx="0" cy="12672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9" name="Line 135"/>
                  <p:cNvSpPr/>
                  <p:nvPr/>
                </p:nvSpPr>
                <p:spPr>
                  <a:xfrm flipH="1">
                    <a:off x="7795440" y="1094760"/>
                    <a:ext cx="152280" cy="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0" name="Line 136"/>
                  <p:cNvSpPr/>
                  <p:nvPr/>
                </p:nvSpPr>
                <p:spPr>
                  <a:xfrm flipH="1">
                    <a:off x="7527600" y="1091520"/>
                    <a:ext cx="149040" cy="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1" name="Line 137"/>
                  <p:cNvSpPr/>
                  <p:nvPr/>
                </p:nvSpPr>
                <p:spPr>
                  <a:xfrm flipH="1">
                    <a:off x="7778160" y="959760"/>
                    <a:ext cx="115560" cy="8892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2120" bIns="421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2" name="Line 138"/>
                  <p:cNvSpPr/>
                  <p:nvPr/>
                </p:nvSpPr>
                <p:spPr>
                  <a:xfrm flipH="1">
                    <a:off x="7581600" y="1134360"/>
                    <a:ext cx="110880" cy="856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8880" bIns="388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3" name="Line 139"/>
                  <p:cNvSpPr/>
                  <p:nvPr/>
                </p:nvSpPr>
                <p:spPr>
                  <a:xfrm flipH="1" flipV="1">
                    <a:off x="7570080" y="938880"/>
                    <a:ext cx="123480" cy="11916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4" name="Line 140"/>
                  <p:cNvSpPr/>
                  <p:nvPr/>
                </p:nvSpPr>
                <p:spPr>
                  <a:xfrm flipH="1" flipV="1">
                    <a:off x="7773480" y="1124640"/>
                    <a:ext cx="110520" cy="11412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5" name="Oval 141"/>
                  <p:cNvSpPr/>
                  <p:nvPr/>
                </p:nvSpPr>
                <p:spPr>
                  <a:xfrm>
                    <a:off x="7532280" y="563040"/>
                    <a:ext cx="131400" cy="115920"/>
                  </a:xfrm>
                  <a:prstGeom prst="ellipse">
                    <a:avLst/>
                  </a:prstGeom>
                  <a:solidFill>
                    <a:srgbClr val="fafd00"/>
                  </a:solidFill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35280" bIns="352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6" name="Line 142"/>
                  <p:cNvSpPr/>
                  <p:nvPr/>
                </p:nvSpPr>
                <p:spPr>
                  <a:xfrm>
                    <a:off x="7597440" y="439200"/>
                    <a:ext cx="0" cy="1252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7" name="Line 143"/>
                  <p:cNvSpPr/>
                  <p:nvPr/>
                </p:nvSpPr>
                <p:spPr>
                  <a:xfrm>
                    <a:off x="7597440" y="685080"/>
                    <a:ext cx="0" cy="1270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8" name="Line 144"/>
                  <p:cNvSpPr/>
                  <p:nvPr/>
                </p:nvSpPr>
                <p:spPr>
                  <a:xfrm flipH="1">
                    <a:off x="7657920" y="624960"/>
                    <a:ext cx="151920" cy="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9" name="Line 145"/>
                  <p:cNvSpPr/>
                  <p:nvPr/>
                </p:nvSpPr>
                <p:spPr>
                  <a:xfrm flipH="1">
                    <a:off x="7390800" y="621720"/>
                    <a:ext cx="147240" cy="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0" name="Line 146"/>
                  <p:cNvSpPr/>
                  <p:nvPr/>
                </p:nvSpPr>
                <p:spPr>
                  <a:xfrm flipH="1">
                    <a:off x="7641720" y="488160"/>
                    <a:ext cx="115560" cy="9072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920" bIns="439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1" name="Line 147"/>
                  <p:cNvSpPr/>
                  <p:nvPr/>
                </p:nvSpPr>
                <p:spPr>
                  <a:xfrm flipH="1">
                    <a:off x="7443360" y="664560"/>
                    <a:ext cx="110520" cy="856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8880" bIns="388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2" name="Line 148"/>
                  <p:cNvSpPr/>
                  <p:nvPr/>
                </p:nvSpPr>
                <p:spPr>
                  <a:xfrm flipH="1" flipV="1">
                    <a:off x="7433640" y="469440"/>
                    <a:ext cx="122040" cy="11880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3" name="Line 149"/>
                  <p:cNvSpPr/>
                  <p:nvPr/>
                </p:nvSpPr>
                <p:spPr>
                  <a:xfrm flipH="1" flipV="1">
                    <a:off x="7637040" y="654840"/>
                    <a:ext cx="109080" cy="11304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4" name="Oval 150"/>
                  <p:cNvSpPr/>
                  <p:nvPr/>
                </p:nvSpPr>
                <p:spPr>
                  <a:xfrm>
                    <a:off x="7073640" y="885240"/>
                    <a:ext cx="131400" cy="114120"/>
                  </a:xfrm>
                  <a:prstGeom prst="ellipse">
                    <a:avLst/>
                  </a:prstGeom>
                  <a:solidFill>
                    <a:srgbClr val="fafd00"/>
                  </a:solidFill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34200" bIns="342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5" name="Line 151"/>
                  <p:cNvSpPr/>
                  <p:nvPr/>
                </p:nvSpPr>
                <p:spPr>
                  <a:xfrm>
                    <a:off x="7140240" y="759960"/>
                    <a:ext cx="0" cy="1252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6" name="Line 152"/>
                  <p:cNvSpPr/>
                  <p:nvPr/>
                </p:nvSpPr>
                <p:spPr>
                  <a:xfrm>
                    <a:off x="7140240" y="1005840"/>
                    <a:ext cx="0" cy="1270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7" name="Line 153"/>
                  <p:cNvSpPr/>
                  <p:nvPr/>
                </p:nvSpPr>
                <p:spPr>
                  <a:xfrm flipH="1">
                    <a:off x="7198560" y="945360"/>
                    <a:ext cx="152280" cy="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8" name="Line 154"/>
                  <p:cNvSpPr/>
                  <p:nvPr/>
                </p:nvSpPr>
                <p:spPr>
                  <a:xfrm flipH="1">
                    <a:off x="6932160" y="943920"/>
                    <a:ext cx="148680" cy="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9" name="Line 155"/>
                  <p:cNvSpPr/>
                  <p:nvPr/>
                </p:nvSpPr>
                <p:spPr>
                  <a:xfrm flipH="1">
                    <a:off x="7182720" y="810720"/>
                    <a:ext cx="115560" cy="9036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560" bIns="435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0" name="Line 156"/>
                  <p:cNvSpPr/>
                  <p:nvPr/>
                </p:nvSpPr>
                <p:spPr>
                  <a:xfrm flipH="1">
                    <a:off x="6984720" y="985320"/>
                    <a:ext cx="110880" cy="856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8880" bIns="388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1" name="Line 157"/>
                  <p:cNvSpPr/>
                  <p:nvPr/>
                </p:nvSpPr>
                <p:spPr>
                  <a:xfrm flipH="1" flipV="1">
                    <a:off x="6975360" y="789480"/>
                    <a:ext cx="121680" cy="11916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2" name="Line 158"/>
                  <p:cNvSpPr/>
                  <p:nvPr/>
                </p:nvSpPr>
                <p:spPr>
                  <a:xfrm flipH="1" flipV="1">
                    <a:off x="7178040" y="975600"/>
                    <a:ext cx="109080" cy="1144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3" name="Oval 159"/>
                  <p:cNvSpPr/>
                  <p:nvPr/>
                </p:nvSpPr>
                <p:spPr>
                  <a:xfrm>
                    <a:off x="7142040" y="551880"/>
                    <a:ext cx="131400" cy="114120"/>
                  </a:xfrm>
                  <a:prstGeom prst="ellipse">
                    <a:avLst/>
                  </a:prstGeom>
                  <a:solidFill>
                    <a:srgbClr val="fafd00"/>
                  </a:solidFill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34200" bIns="342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4" name="Line 160"/>
                  <p:cNvSpPr/>
                  <p:nvPr/>
                </p:nvSpPr>
                <p:spPr>
                  <a:xfrm>
                    <a:off x="7208640" y="428040"/>
                    <a:ext cx="0" cy="1252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5" name="Line 161"/>
                  <p:cNvSpPr/>
                  <p:nvPr/>
                </p:nvSpPr>
                <p:spPr>
                  <a:xfrm>
                    <a:off x="7208640" y="673920"/>
                    <a:ext cx="0" cy="12564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6" name="Line 162"/>
                  <p:cNvSpPr/>
                  <p:nvPr/>
                </p:nvSpPr>
                <p:spPr>
                  <a:xfrm flipH="1">
                    <a:off x="7268760" y="613800"/>
                    <a:ext cx="150480" cy="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7" name="Line 163"/>
                  <p:cNvSpPr/>
                  <p:nvPr/>
                </p:nvSpPr>
                <p:spPr>
                  <a:xfrm flipH="1">
                    <a:off x="7000560" y="610560"/>
                    <a:ext cx="149040" cy="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8" name="Line 164"/>
                  <p:cNvSpPr/>
                  <p:nvPr/>
                </p:nvSpPr>
                <p:spPr>
                  <a:xfrm flipH="1">
                    <a:off x="7251120" y="477360"/>
                    <a:ext cx="115560" cy="9036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3560" bIns="4356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9" name="Line 165"/>
                  <p:cNvSpPr/>
                  <p:nvPr/>
                </p:nvSpPr>
                <p:spPr>
                  <a:xfrm flipH="1">
                    <a:off x="7053120" y="651960"/>
                    <a:ext cx="112320" cy="856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8880" bIns="388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0" name="Line 166"/>
                  <p:cNvSpPr/>
                  <p:nvPr/>
                </p:nvSpPr>
                <p:spPr>
                  <a:xfrm flipH="1" flipV="1">
                    <a:off x="7043040" y="458280"/>
                    <a:ext cx="123480" cy="11736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1" name="Line 167"/>
                  <p:cNvSpPr/>
                  <p:nvPr/>
                </p:nvSpPr>
                <p:spPr>
                  <a:xfrm flipH="1" flipV="1">
                    <a:off x="7246440" y="643680"/>
                    <a:ext cx="110520" cy="1126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2" name="Oval 168"/>
                  <p:cNvSpPr/>
                  <p:nvPr/>
                </p:nvSpPr>
                <p:spPr>
                  <a:xfrm>
                    <a:off x="6460920" y="1136160"/>
                    <a:ext cx="131400" cy="115920"/>
                  </a:xfrm>
                  <a:prstGeom prst="ellipse">
                    <a:avLst/>
                  </a:prstGeom>
                  <a:solidFill>
                    <a:srgbClr val="fafd00"/>
                  </a:solidFill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35280" bIns="352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3" name="Line 169"/>
                  <p:cNvSpPr/>
                  <p:nvPr/>
                </p:nvSpPr>
                <p:spPr>
                  <a:xfrm>
                    <a:off x="6526080" y="1012320"/>
                    <a:ext cx="0" cy="1252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4" name="Line 170"/>
                  <p:cNvSpPr/>
                  <p:nvPr/>
                </p:nvSpPr>
                <p:spPr>
                  <a:xfrm>
                    <a:off x="6526080" y="1258200"/>
                    <a:ext cx="0" cy="1270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5" name="Line 171"/>
                  <p:cNvSpPr/>
                  <p:nvPr/>
                </p:nvSpPr>
                <p:spPr>
                  <a:xfrm flipH="1">
                    <a:off x="6585840" y="1198080"/>
                    <a:ext cx="152280" cy="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6" name="Line 172"/>
                  <p:cNvSpPr/>
                  <p:nvPr/>
                </p:nvSpPr>
                <p:spPr>
                  <a:xfrm flipH="1">
                    <a:off x="6318000" y="1194840"/>
                    <a:ext cx="149040" cy="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7" name="Line 173"/>
                  <p:cNvSpPr/>
                  <p:nvPr/>
                </p:nvSpPr>
                <p:spPr>
                  <a:xfrm flipH="1">
                    <a:off x="6568560" y="1063080"/>
                    <a:ext cx="115560" cy="8892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2120" bIns="421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8" name="Line 174"/>
                  <p:cNvSpPr/>
                  <p:nvPr/>
                </p:nvSpPr>
                <p:spPr>
                  <a:xfrm flipH="1">
                    <a:off x="6372000" y="1237680"/>
                    <a:ext cx="110880" cy="856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8880" bIns="388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9" name="Line 175"/>
                  <p:cNvSpPr/>
                  <p:nvPr/>
                </p:nvSpPr>
                <p:spPr>
                  <a:xfrm flipH="1" flipV="1">
                    <a:off x="6360480" y="1041840"/>
                    <a:ext cx="123480" cy="11916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0" name="Line 176"/>
                  <p:cNvSpPr/>
                  <p:nvPr/>
                </p:nvSpPr>
                <p:spPr>
                  <a:xfrm flipH="1" flipV="1">
                    <a:off x="6563880" y="1227960"/>
                    <a:ext cx="110520" cy="114480"/>
                  </a:xfrm>
                  <a:prstGeom prst="line">
                    <a:avLst/>
                  </a:prstGeom>
                  <a:ln w="12600">
                    <a:solidFill>
                      <a:srgbClr val="ffdc44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1" name="Oval 177"/>
                  <p:cNvSpPr/>
                  <p:nvPr/>
                </p:nvSpPr>
                <p:spPr>
                  <a:xfrm>
                    <a:off x="5679720" y="1872720"/>
                    <a:ext cx="56880" cy="5688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480" bIns="-64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2" name="Oval 178"/>
                  <p:cNvSpPr/>
                  <p:nvPr/>
                </p:nvSpPr>
                <p:spPr>
                  <a:xfrm>
                    <a:off x="5432400" y="1609200"/>
                    <a:ext cx="56880" cy="5688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480" bIns="-64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3" name="Oval 179"/>
                  <p:cNvSpPr/>
                  <p:nvPr/>
                </p:nvSpPr>
                <p:spPr>
                  <a:xfrm>
                    <a:off x="5805360" y="1883880"/>
                    <a:ext cx="56520" cy="5688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480" bIns="-64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4" name="Freeform 181"/>
                  <p:cNvSpPr/>
                  <p:nvPr/>
                </p:nvSpPr>
                <p:spPr>
                  <a:xfrm>
                    <a:off x="6687720" y="1574280"/>
                    <a:ext cx="150480" cy="137880"/>
                  </a:xfrm>
                  <a:custGeom>
                    <a:avLst/>
                    <a:gdLst>
                      <a:gd name="textAreaLeft" fmla="*/ 0 w 150480"/>
                      <a:gd name="textAreaRight" fmla="*/ 150840 w 150480"/>
                      <a:gd name="textAreaTop" fmla="*/ 0 h 137880"/>
                      <a:gd name="textAreaBottom" fmla="*/ 138240 h 137880"/>
                    </a:gdLst>
                    <a:ahLst/>
                    <a:rect l="textAreaLeft" t="textAreaTop" r="textAreaRight" b="textAreaBottom"/>
                    <a:pathLst>
                      <a:path w="105" h="97">
                        <a:moveTo>
                          <a:pt x="104" y="0"/>
                        </a:moveTo>
                        <a:lnTo>
                          <a:pt x="88" y="0"/>
                        </a:lnTo>
                        <a:lnTo>
                          <a:pt x="72" y="0"/>
                        </a:lnTo>
                        <a:lnTo>
                          <a:pt x="64" y="16"/>
                        </a:lnTo>
                        <a:lnTo>
                          <a:pt x="56" y="32"/>
                        </a:lnTo>
                        <a:lnTo>
                          <a:pt x="56" y="48"/>
                        </a:lnTo>
                        <a:lnTo>
                          <a:pt x="56" y="64"/>
                        </a:lnTo>
                        <a:lnTo>
                          <a:pt x="56" y="80"/>
                        </a:lnTo>
                        <a:lnTo>
                          <a:pt x="48" y="96"/>
                        </a:lnTo>
                        <a:lnTo>
                          <a:pt x="32" y="96"/>
                        </a:lnTo>
                        <a:lnTo>
                          <a:pt x="16" y="96"/>
                        </a:lnTo>
                        <a:lnTo>
                          <a:pt x="8" y="80"/>
                        </a:lnTo>
                        <a:lnTo>
                          <a:pt x="0" y="80"/>
                        </a:lnTo>
                        <a:lnTo>
                          <a:pt x="0" y="80"/>
                        </a:lnTo>
                      </a:path>
                    </a:pathLst>
                  </a:custGeom>
                  <a:noFill/>
                  <a:ln cap="rnd" w="2844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5" name="Freeform 182"/>
                  <p:cNvSpPr/>
                  <p:nvPr/>
                </p:nvSpPr>
                <p:spPr>
                  <a:xfrm>
                    <a:off x="7341840" y="1436040"/>
                    <a:ext cx="150480" cy="139680"/>
                  </a:xfrm>
                  <a:custGeom>
                    <a:avLst/>
                    <a:gdLst>
                      <a:gd name="textAreaLeft" fmla="*/ 0 w 150480"/>
                      <a:gd name="textAreaRight" fmla="*/ 150840 w 150480"/>
                      <a:gd name="textAreaTop" fmla="*/ 0 h 139680"/>
                      <a:gd name="textAreaBottom" fmla="*/ 140040 h 139680"/>
                    </a:gdLst>
                    <a:ahLst/>
                    <a:rect l="textAreaLeft" t="textAreaTop" r="textAreaRight" b="textAreaBottom"/>
                    <a:pathLst>
                      <a:path w="105" h="97">
                        <a:moveTo>
                          <a:pt x="104" y="0"/>
                        </a:moveTo>
                        <a:lnTo>
                          <a:pt x="88" y="0"/>
                        </a:lnTo>
                        <a:lnTo>
                          <a:pt x="72" y="0"/>
                        </a:lnTo>
                        <a:lnTo>
                          <a:pt x="64" y="16"/>
                        </a:lnTo>
                        <a:lnTo>
                          <a:pt x="56" y="32"/>
                        </a:lnTo>
                        <a:lnTo>
                          <a:pt x="56" y="48"/>
                        </a:lnTo>
                        <a:lnTo>
                          <a:pt x="56" y="64"/>
                        </a:lnTo>
                        <a:lnTo>
                          <a:pt x="56" y="80"/>
                        </a:lnTo>
                        <a:lnTo>
                          <a:pt x="48" y="96"/>
                        </a:lnTo>
                        <a:lnTo>
                          <a:pt x="32" y="96"/>
                        </a:lnTo>
                        <a:lnTo>
                          <a:pt x="16" y="96"/>
                        </a:lnTo>
                        <a:lnTo>
                          <a:pt x="8" y="80"/>
                        </a:lnTo>
                        <a:lnTo>
                          <a:pt x="0" y="80"/>
                        </a:lnTo>
                        <a:lnTo>
                          <a:pt x="0" y="80"/>
                        </a:lnTo>
                      </a:path>
                    </a:pathLst>
                  </a:custGeom>
                  <a:noFill/>
                  <a:ln cap="rnd" w="2844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6" name="Oval 183"/>
                  <p:cNvSpPr/>
                  <p:nvPr/>
                </p:nvSpPr>
                <p:spPr>
                  <a:xfrm>
                    <a:off x="5466960" y="1447200"/>
                    <a:ext cx="56880" cy="5868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5400" bIns="-54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7" name="Line 212"/>
                  <p:cNvSpPr/>
                  <p:nvPr/>
                </p:nvSpPr>
                <p:spPr>
                  <a:xfrm>
                    <a:off x="6911640" y="1563120"/>
                    <a:ext cx="412560" cy="0"/>
                  </a:xfrm>
                  <a:prstGeom prst="line">
                    <a:avLst/>
                  </a:prstGeom>
                  <a:ln w="28440">
                    <a:solidFill>
                      <a:srgbClr val="ff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8" name="Rectangle 216"/>
                  <p:cNvSpPr/>
                  <p:nvPr/>
                </p:nvSpPr>
                <p:spPr>
                  <a:xfrm>
                    <a:off x="7284960" y="1534320"/>
                    <a:ext cx="61560" cy="68400"/>
                  </a:xfrm>
                  <a:prstGeom prst="rect">
                    <a:avLst/>
                  </a:prstGeom>
                  <a:solidFill>
                    <a:srgbClr val="5f5f5f"/>
                  </a:solid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21600" bIns="216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9" name="Rectangle 217"/>
                  <p:cNvSpPr/>
                  <p:nvPr/>
                </p:nvSpPr>
                <p:spPr>
                  <a:xfrm>
                    <a:off x="6843600" y="1534320"/>
                    <a:ext cx="63000" cy="68400"/>
                  </a:xfrm>
                  <a:prstGeom prst="rect">
                    <a:avLst/>
                  </a:prstGeom>
                  <a:solidFill>
                    <a:srgbClr val="5f5f5f"/>
                  </a:solid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21600" bIns="216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10" name="Group 239"/>
                <p:cNvGrpSpPr/>
                <p:nvPr/>
              </p:nvGrpSpPr>
              <p:grpSpPr>
                <a:xfrm>
                  <a:off x="942480" y="1969920"/>
                  <a:ext cx="2501640" cy="1743120"/>
                  <a:chOff x="942480" y="1969920"/>
                  <a:chExt cx="2501640" cy="1743120"/>
                </a:xfrm>
              </p:grpSpPr>
              <p:sp>
                <p:nvSpPr>
                  <p:cNvPr id="211" name="Freeform 5"/>
                  <p:cNvSpPr/>
                  <p:nvPr/>
                </p:nvSpPr>
                <p:spPr>
                  <a:xfrm>
                    <a:off x="942480" y="1969920"/>
                    <a:ext cx="2501640" cy="1743120"/>
                  </a:xfrm>
                  <a:custGeom>
                    <a:avLst/>
                    <a:gdLst>
                      <a:gd name="textAreaLeft" fmla="*/ 0 w 2501640"/>
                      <a:gd name="textAreaRight" fmla="*/ 2502000 w 2501640"/>
                      <a:gd name="textAreaTop" fmla="*/ 0 h 1743120"/>
                      <a:gd name="textAreaBottom" fmla="*/ 1743480 h 1743120"/>
                    </a:gdLst>
                    <a:ahLst/>
                    <a:rect l="textAreaLeft" t="textAreaTop" r="textAreaRight" b="textAreaBottom"/>
                    <a:pathLst>
                      <a:path w="1745" h="1217">
                        <a:moveTo>
                          <a:pt x="168" y="672"/>
                        </a:moveTo>
                        <a:lnTo>
                          <a:pt x="201" y="663"/>
                        </a:lnTo>
                        <a:lnTo>
                          <a:pt x="233" y="647"/>
                        </a:lnTo>
                        <a:lnTo>
                          <a:pt x="297" y="630"/>
                        </a:lnTo>
                        <a:lnTo>
                          <a:pt x="362" y="614"/>
                        </a:lnTo>
                        <a:lnTo>
                          <a:pt x="426" y="582"/>
                        </a:lnTo>
                        <a:lnTo>
                          <a:pt x="490" y="549"/>
                        </a:lnTo>
                        <a:lnTo>
                          <a:pt x="538" y="516"/>
                        </a:lnTo>
                        <a:lnTo>
                          <a:pt x="592" y="476"/>
                        </a:lnTo>
                        <a:lnTo>
                          <a:pt x="635" y="435"/>
                        </a:lnTo>
                        <a:lnTo>
                          <a:pt x="663" y="419"/>
                        </a:lnTo>
                        <a:lnTo>
                          <a:pt x="699" y="386"/>
                        </a:lnTo>
                        <a:lnTo>
                          <a:pt x="731" y="354"/>
                        </a:lnTo>
                        <a:lnTo>
                          <a:pt x="764" y="321"/>
                        </a:lnTo>
                        <a:lnTo>
                          <a:pt x="828" y="272"/>
                        </a:lnTo>
                        <a:lnTo>
                          <a:pt x="876" y="240"/>
                        </a:lnTo>
                        <a:lnTo>
                          <a:pt x="908" y="207"/>
                        </a:lnTo>
                        <a:lnTo>
                          <a:pt x="961" y="169"/>
                        </a:lnTo>
                        <a:lnTo>
                          <a:pt x="1005" y="142"/>
                        </a:lnTo>
                        <a:lnTo>
                          <a:pt x="1040" y="124"/>
                        </a:lnTo>
                        <a:lnTo>
                          <a:pt x="1080" y="96"/>
                        </a:lnTo>
                        <a:lnTo>
                          <a:pt x="1117" y="77"/>
                        </a:lnTo>
                        <a:lnTo>
                          <a:pt x="1164" y="48"/>
                        </a:lnTo>
                        <a:lnTo>
                          <a:pt x="1235" y="22"/>
                        </a:lnTo>
                        <a:lnTo>
                          <a:pt x="1278" y="12"/>
                        </a:lnTo>
                        <a:lnTo>
                          <a:pt x="1336" y="0"/>
                        </a:lnTo>
                        <a:lnTo>
                          <a:pt x="1368" y="0"/>
                        </a:lnTo>
                        <a:lnTo>
                          <a:pt x="1404" y="0"/>
                        </a:lnTo>
                        <a:lnTo>
                          <a:pt x="1448" y="8"/>
                        </a:lnTo>
                        <a:lnTo>
                          <a:pt x="1502" y="18"/>
                        </a:lnTo>
                        <a:lnTo>
                          <a:pt x="1547" y="33"/>
                        </a:lnTo>
                        <a:lnTo>
                          <a:pt x="1596" y="52"/>
                        </a:lnTo>
                        <a:lnTo>
                          <a:pt x="1648" y="94"/>
                        </a:lnTo>
                        <a:lnTo>
                          <a:pt x="1680" y="126"/>
                        </a:lnTo>
                        <a:lnTo>
                          <a:pt x="1709" y="167"/>
                        </a:lnTo>
                        <a:lnTo>
                          <a:pt x="1728" y="224"/>
                        </a:lnTo>
                        <a:lnTo>
                          <a:pt x="1744" y="289"/>
                        </a:lnTo>
                        <a:lnTo>
                          <a:pt x="1744" y="321"/>
                        </a:lnTo>
                        <a:lnTo>
                          <a:pt x="1744" y="354"/>
                        </a:lnTo>
                        <a:lnTo>
                          <a:pt x="1744" y="386"/>
                        </a:lnTo>
                        <a:lnTo>
                          <a:pt x="1744" y="451"/>
                        </a:lnTo>
                        <a:lnTo>
                          <a:pt x="1740" y="500"/>
                        </a:lnTo>
                        <a:lnTo>
                          <a:pt x="1728" y="565"/>
                        </a:lnTo>
                        <a:lnTo>
                          <a:pt x="1720" y="602"/>
                        </a:lnTo>
                        <a:lnTo>
                          <a:pt x="1705" y="659"/>
                        </a:lnTo>
                        <a:lnTo>
                          <a:pt x="1693" y="700"/>
                        </a:lnTo>
                        <a:lnTo>
                          <a:pt x="1676" y="736"/>
                        </a:lnTo>
                        <a:lnTo>
                          <a:pt x="1660" y="776"/>
                        </a:lnTo>
                        <a:lnTo>
                          <a:pt x="1631" y="826"/>
                        </a:lnTo>
                        <a:lnTo>
                          <a:pt x="1615" y="858"/>
                        </a:lnTo>
                        <a:lnTo>
                          <a:pt x="1599" y="891"/>
                        </a:lnTo>
                        <a:lnTo>
                          <a:pt x="1567" y="939"/>
                        </a:lnTo>
                        <a:lnTo>
                          <a:pt x="1519" y="988"/>
                        </a:lnTo>
                        <a:lnTo>
                          <a:pt x="1487" y="1021"/>
                        </a:lnTo>
                        <a:lnTo>
                          <a:pt x="1455" y="1053"/>
                        </a:lnTo>
                        <a:lnTo>
                          <a:pt x="1406" y="1086"/>
                        </a:lnTo>
                        <a:lnTo>
                          <a:pt x="1381" y="1098"/>
                        </a:lnTo>
                        <a:lnTo>
                          <a:pt x="1345" y="1110"/>
                        </a:lnTo>
                        <a:lnTo>
                          <a:pt x="1302" y="1127"/>
                        </a:lnTo>
                        <a:lnTo>
                          <a:pt x="1214" y="1151"/>
                        </a:lnTo>
                        <a:lnTo>
                          <a:pt x="1149" y="1167"/>
                        </a:lnTo>
                        <a:lnTo>
                          <a:pt x="1101" y="1183"/>
                        </a:lnTo>
                        <a:lnTo>
                          <a:pt x="1042" y="1188"/>
                        </a:lnTo>
                        <a:lnTo>
                          <a:pt x="989" y="1200"/>
                        </a:lnTo>
                        <a:lnTo>
                          <a:pt x="940" y="1200"/>
                        </a:lnTo>
                        <a:lnTo>
                          <a:pt x="884" y="1208"/>
                        </a:lnTo>
                        <a:lnTo>
                          <a:pt x="825" y="1208"/>
                        </a:lnTo>
                        <a:lnTo>
                          <a:pt x="764" y="1216"/>
                        </a:lnTo>
                        <a:lnTo>
                          <a:pt x="715" y="1216"/>
                        </a:lnTo>
                        <a:lnTo>
                          <a:pt x="683" y="1216"/>
                        </a:lnTo>
                        <a:lnTo>
                          <a:pt x="603" y="1216"/>
                        </a:lnTo>
                        <a:lnTo>
                          <a:pt x="555" y="1216"/>
                        </a:lnTo>
                        <a:lnTo>
                          <a:pt x="474" y="1216"/>
                        </a:lnTo>
                        <a:lnTo>
                          <a:pt x="426" y="1216"/>
                        </a:lnTo>
                        <a:lnTo>
                          <a:pt x="383" y="1212"/>
                        </a:lnTo>
                        <a:lnTo>
                          <a:pt x="307" y="1196"/>
                        </a:lnTo>
                        <a:lnTo>
                          <a:pt x="281" y="1183"/>
                        </a:lnTo>
                        <a:lnTo>
                          <a:pt x="233" y="1163"/>
                        </a:lnTo>
                        <a:lnTo>
                          <a:pt x="205" y="1147"/>
                        </a:lnTo>
                        <a:lnTo>
                          <a:pt x="169" y="1118"/>
                        </a:lnTo>
                        <a:lnTo>
                          <a:pt x="138" y="1094"/>
                        </a:lnTo>
                        <a:lnTo>
                          <a:pt x="88" y="1053"/>
                        </a:lnTo>
                        <a:lnTo>
                          <a:pt x="56" y="1021"/>
                        </a:lnTo>
                        <a:lnTo>
                          <a:pt x="31" y="992"/>
                        </a:lnTo>
                        <a:lnTo>
                          <a:pt x="16" y="964"/>
                        </a:lnTo>
                        <a:lnTo>
                          <a:pt x="0" y="920"/>
                        </a:lnTo>
                        <a:lnTo>
                          <a:pt x="0" y="887"/>
                        </a:lnTo>
                        <a:lnTo>
                          <a:pt x="12" y="842"/>
                        </a:lnTo>
                        <a:lnTo>
                          <a:pt x="24" y="809"/>
                        </a:lnTo>
                        <a:lnTo>
                          <a:pt x="40" y="777"/>
                        </a:lnTo>
                        <a:lnTo>
                          <a:pt x="63" y="752"/>
                        </a:lnTo>
                        <a:lnTo>
                          <a:pt x="88" y="728"/>
                        </a:lnTo>
                        <a:lnTo>
                          <a:pt x="121" y="695"/>
                        </a:lnTo>
                        <a:lnTo>
                          <a:pt x="153" y="679"/>
                        </a:lnTo>
                        <a:lnTo>
                          <a:pt x="156" y="684"/>
                        </a:lnTo>
                        <a:lnTo>
                          <a:pt x="168" y="672"/>
                        </a:lnTo>
                      </a:path>
                    </a:pathLst>
                  </a:custGeom>
                  <a:blipFill rotWithShape="0">
                    <a:blip r:embed="rId2"/>
                    <a:srcRect/>
                    <a:stretch/>
                  </a:blipFill>
                  <a:ln cap="rnd"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2" name="Oval 6"/>
                  <p:cNvSpPr/>
                  <p:nvPr/>
                </p:nvSpPr>
                <p:spPr>
                  <a:xfrm rot="19680000">
                    <a:off x="1820160" y="2496600"/>
                    <a:ext cx="1247760" cy="600120"/>
                  </a:xfrm>
                  <a:prstGeom prst="ellipse">
                    <a:avLst/>
                  </a:prstGeom>
                  <a:gradFill rotWithShape="0">
                    <a:gsLst>
                      <a:gs pos="0">
                        <a:srgbClr val="cc99ff"/>
                      </a:gs>
                      <a:gs pos="100000">
                        <a:srgbClr val="5e4776"/>
                      </a:gs>
                    </a:gsLst>
                    <a:path path="rect">
                      <a:fillToRect l="50000" t="50000" r="50000" b="50000"/>
                    </a:path>
                  </a:gradFill>
                  <a:ln w="19080">
                    <a:solidFill>
                      <a:srgbClr val="bbe0e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3" name="Oval 23"/>
                  <p:cNvSpPr/>
                  <p:nvPr/>
                </p:nvSpPr>
                <p:spPr>
                  <a:xfrm>
                    <a:off x="2107440" y="2887560"/>
                    <a:ext cx="252720" cy="158760"/>
                  </a:xfrm>
                  <a:prstGeom prst="ellipse">
                    <a:avLst/>
                  </a:prstGeom>
                  <a:noFill/>
                  <a:ln w="28440">
                    <a:solidFill>
                      <a:srgbClr val="3366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4" name="Oval 24"/>
                  <p:cNvSpPr/>
                  <p:nvPr/>
                </p:nvSpPr>
                <p:spPr>
                  <a:xfrm>
                    <a:off x="2360160" y="2624040"/>
                    <a:ext cx="412560" cy="249480"/>
                  </a:xfrm>
                  <a:prstGeom prst="ellipse">
                    <a:avLst/>
                  </a:prstGeom>
                  <a:noFill/>
                  <a:ln w="28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15" name="Rectangle 25"/>
                <p:cNvSpPr/>
                <p:nvPr/>
              </p:nvSpPr>
              <p:spPr>
                <a:xfrm>
                  <a:off x="475920" y="1906560"/>
                  <a:ext cx="1941480" cy="3938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360" rIns="90360" tIns="44280" bIns="4428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20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Transfection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6" name="Line 26"/>
                <p:cNvSpPr/>
                <p:nvPr/>
              </p:nvSpPr>
              <p:spPr>
                <a:xfrm>
                  <a:off x="2268360" y="1425240"/>
                  <a:ext cx="0" cy="10429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7" name="Rectangle 27"/>
                <p:cNvSpPr/>
                <p:nvPr/>
              </p:nvSpPr>
              <p:spPr>
                <a:xfrm>
                  <a:off x="2130120" y="156600"/>
                  <a:ext cx="2752560" cy="72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360" rIns="90360" tIns="44280" bIns="4428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HIV </a:t>
                  </a:r>
                  <a:r>
                    <a:rPr b="1" i="1" lang="en-US" sz="14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env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 expression vector containing patient’s PCR-amplified HIV </a:t>
                  </a:r>
                  <a:r>
                    <a:rPr b="1" i="1" lang="en-US" sz="14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env</a:t>
                  </a: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 fragments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8" name="Rectangle 28"/>
                <p:cNvSpPr/>
                <p:nvPr/>
              </p:nvSpPr>
              <p:spPr>
                <a:xfrm>
                  <a:off x="2068200" y="909360"/>
                  <a:ext cx="419040" cy="576360"/>
                </a:xfrm>
                <a:prstGeom prst="rect">
                  <a:avLst/>
                </a:prstGeom>
                <a:noFill/>
                <a:ln w="0">
                  <a:noFill/>
                </a:ln>
                <a:effectLst>
                  <a:outerShdw dist="17819" dir="2700000" blurRad="0" rotWithShape="0">
                    <a:srgbClr val="232323"/>
                  </a:outerShdw>
                </a:effectLst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360" rIns="90360" tIns="44280" bIns="4428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32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+</a:t>
                  </a:r>
                  <a:endParaRPr b="0" lang="en-US" sz="3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9" name="Rectangle 29"/>
                <p:cNvSpPr/>
                <p:nvPr/>
              </p:nvSpPr>
              <p:spPr>
                <a:xfrm>
                  <a:off x="369000" y="680760"/>
                  <a:ext cx="1600200" cy="5151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360" rIns="90360" tIns="44280" bIns="4428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HIV genomic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luciferase vector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0" name="Oval 30"/>
                <p:cNvSpPr/>
                <p:nvPr/>
              </p:nvSpPr>
              <p:spPr>
                <a:xfrm>
                  <a:off x="1240920" y="1258560"/>
                  <a:ext cx="647640" cy="388800"/>
                </a:xfrm>
                <a:prstGeom prst="ellipse">
                  <a:avLst/>
                </a:prstGeom>
                <a:noFill/>
                <a:ln w="28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1" name="Freeform 31"/>
                <p:cNvSpPr/>
                <p:nvPr/>
              </p:nvSpPr>
              <p:spPr>
                <a:xfrm>
                  <a:off x="1393560" y="1258560"/>
                  <a:ext cx="330120" cy="28440"/>
                </a:xfrm>
                <a:custGeom>
                  <a:avLst/>
                  <a:gdLst>
                    <a:gd name="textAreaLeft" fmla="*/ 0 w 330120"/>
                    <a:gd name="textAreaRight" fmla="*/ 330480 w 330120"/>
                    <a:gd name="textAreaTop" fmla="*/ 0 h 28440"/>
                    <a:gd name="textAreaBottom" fmla="*/ 28800 h 28440"/>
                  </a:gdLst>
                  <a:ahLst/>
                  <a:rect l="textAreaLeft" t="textAreaTop" r="textAreaRight" b="textAreaBottom"/>
                  <a:pathLst>
                    <a:path w="230" h="20">
                      <a:moveTo>
                        <a:pt x="0" y="20"/>
                      </a:moveTo>
                      <a:lnTo>
                        <a:pt x="50" y="8"/>
                      </a:lnTo>
                      <a:lnTo>
                        <a:pt x="118" y="0"/>
                      </a:lnTo>
                      <a:lnTo>
                        <a:pt x="158" y="4"/>
                      </a:lnTo>
                      <a:lnTo>
                        <a:pt x="230" y="16"/>
                      </a:lnTo>
                    </a:path>
                  </a:pathLst>
                </a:custGeom>
                <a:solidFill>
                  <a:srgbClr val="dec110"/>
                </a:solidFill>
                <a:ln w="38160">
                  <a:solidFill>
                    <a:srgbClr val="ff0066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8000" bIns="-180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2" name="Rectangle 32"/>
                <p:cNvSpPr/>
                <p:nvPr/>
              </p:nvSpPr>
              <p:spPr>
                <a:xfrm>
                  <a:off x="1364760" y="1239480"/>
                  <a:ext cx="64800" cy="77760"/>
                </a:xfrm>
                <a:prstGeom prst="rect">
                  <a:avLst/>
                </a:prstGeom>
                <a:solidFill>
                  <a:srgbClr val="5f5f5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30960" bIns="3096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3" name="Rectangle 33"/>
                <p:cNvSpPr/>
                <p:nvPr/>
              </p:nvSpPr>
              <p:spPr>
                <a:xfrm>
                  <a:off x="1680840" y="1239480"/>
                  <a:ext cx="61560" cy="77760"/>
                </a:xfrm>
                <a:prstGeom prst="rect">
                  <a:avLst/>
                </a:prstGeom>
                <a:solidFill>
                  <a:srgbClr val="5f5f5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30960" bIns="3096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4" name="Text Box 34"/>
                <p:cNvSpPr/>
                <p:nvPr/>
              </p:nvSpPr>
              <p:spPr>
                <a:xfrm>
                  <a:off x="7563240" y="3809880"/>
                  <a:ext cx="1043280" cy="672840"/>
                </a:xfrm>
                <a:prstGeom prst="rect">
                  <a:avLst/>
                </a:prstGeom>
                <a:solidFill>
                  <a:srgbClr val="cc66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900" spc="-1" strike="noStrike">
                      <a:solidFill>
                        <a:srgbClr val="ffffff"/>
                      </a:solidFill>
                      <a:latin typeface="Arial"/>
                      <a:ea typeface="ＭＳ Ｐゴシック"/>
                    </a:rPr>
                    <a:t>CD4 +</a:t>
                  </a:r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900" spc="-1" strike="noStrike">
                      <a:solidFill>
                        <a:srgbClr val="ffffff"/>
                      </a:solidFill>
                      <a:latin typeface="Arial"/>
                      <a:ea typeface="ＭＳ Ｐゴシック"/>
                    </a:rPr>
                    <a:t>CCR5 +</a:t>
                  </a:r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5" name="Rectangle 110"/>
                <p:cNvSpPr/>
                <p:nvPr/>
              </p:nvSpPr>
              <p:spPr>
                <a:xfrm>
                  <a:off x="7629480" y="2003400"/>
                  <a:ext cx="1242000" cy="3938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360" rIns="90360" tIns="44280" bIns="4428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20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Infection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6" name="Line 180"/>
                <p:cNvSpPr/>
                <p:nvPr/>
              </p:nvSpPr>
              <p:spPr>
                <a:xfrm>
                  <a:off x="5956200" y="1761840"/>
                  <a:ext cx="718920" cy="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7" name="Text Box 184"/>
                <p:cNvSpPr/>
                <p:nvPr/>
              </p:nvSpPr>
              <p:spPr>
                <a:xfrm>
                  <a:off x="5234400" y="153720"/>
                  <a:ext cx="1203480" cy="6728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900" spc="-1" strike="noStrike">
                      <a:solidFill>
                        <a:srgbClr val="ffffff"/>
                      </a:solidFill>
                      <a:latin typeface="Arial"/>
                      <a:ea typeface="ＭＳ Ｐゴシック"/>
                    </a:rPr>
                    <a:t>CD4 +</a:t>
                  </a:r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900" spc="-1" strike="noStrike">
                      <a:solidFill>
                        <a:srgbClr val="ffffff"/>
                      </a:solidFill>
                      <a:latin typeface="Arial"/>
                      <a:ea typeface="ＭＳ Ｐゴシック"/>
                    </a:rPr>
                    <a:t>CXCR4 +</a:t>
                  </a:r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8" name="Line 185"/>
                <p:cNvSpPr/>
                <p:nvPr/>
              </p:nvSpPr>
              <p:spPr>
                <a:xfrm>
                  <a:off x="3057120" y="2903400"/>
                  <a:ext cx="744480" cy="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29" name="Group 238"/>
                <p:cNvGrpSpPr/>
                <p:nvPr/>
              </p:nvGrpSpPr>
              <p:grpSpPr>
                <a:xfrm>
                  <a:off x="3786120" y="2681280"/>
                  <a:ext cx="838080" cy="515880"/>
                  <a:chOff x="3786120" y="2681280"/>
                  <a:chExt cx="838080" cy="515880"/>
                </a:xfrm>
              </p:grpSpPr>
              <p:sp>
                <p:nvSpPr>
                  <p:cNvPr id="230" name="Oval 186"/>
                  <p:cNvSpPr/>
                  <p:nvPr/>
                </p:nvSpPr>
                <p:spPr>
                  <a:xfrm>
                    <a:off x="3900240" y="3048120"/>
                    <a:ext cx="5724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1" name="Oval 187"/>
                  <p:cNvSpPr/>
                  <p:nvPr/>
                </p:nvSpPr>
                <p:spPr>
                  <a:xfrm>
                    <a:off x="4049640" y="3127320"/>
                    <a:ext cx="57240" cy="5868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5400" bIns="-54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2" name="Oval 188"/>
                  <p:cNvSpPr/>
                  <p:nvPr/>
                </p:nvSpPr>
                <p:spPr>
                  <a:xfrm>
                    <a:off x="4278240" y="2681280"/>
                    <a:ext cx="5724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3" name="Oval 189"/>
                  <p:cNvSpPr/>
                  <p:nvPr/>
                </p:nvSpPr>
                <p:spPr>
                  <a:xfrm>
                    <a:off x="4082760" y="2967120"/>
                    <a:ext cx="5904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4" name="Oval 190"/>
                  <p:cNvSpPr/>
                  <p:nvPr/>
                </p:nvSpPr>
                <p:spPr>
                  <a:xfrm>
                    <a:off x="4049640" y="2703600"/>
                    <a:ext cx="5724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5" name="Oval 191"/>
                  <p:cNvSpPr/>
                  <p:nvPr/>
                </p:nvSpPr>
                <p:spPr>
                  <a:xfrm>
                    <a:off x="4209840" y="3140280"/>
                    <a:ext cx="57240" cy="5688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480" bIns="-64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6" name="Oval 192"/>
                  <p:cNvSpPr/>
                  <p:nvPr/>
                </p:nvSpPr>
                <p:spPr>
                  <a:xfrm>
                    <a:off x="4152600" y="2830680"/>
                    <a:ext cx="57240" cy="5688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480" bIns="-64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7" name="Oval 193"/>
                  <p:cNvSpPr/>
                  <p:nvPr/>
                </p:nvSpPr>
                <p:spPr>
                  <a:xfrm>
                    <a:off x="3786120" y="3116160"/>
                    <a:ext cx="5724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8" name="Oval 194"/>
                  <p:cNvSpPr/>
                  <p:nvPr/>
                </p:nvSpPr>
                <p:spPr>
                  <a:xfrm>
                    <a:off x="4324320" y="2841840"/>
                    <a:ext cx="56880" cy="5688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480" bIns="-64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9" name="Oval 195"/>
                  <p:cNvSpPr/>
                  <p:nvPr/>
                </p:nvSpPr>
                <p:spPr>
                  <a:xfrm>
                    <a:off x="4232160" y="3002040"/>
                    <a:ext cx="5724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0" name="Oval 196"/>
                  <p:cNvSpPr/>
                  <p:nvPr/>
                </p:nvSpPr>
                <p:spPr>
                  <a:xfrm>
                    <a:off x="4416120" y="3024360"/>
                    <a:ext cx="57240" cy="5688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480" bIns="-64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1" name="Oval 197"/>
                  <p:cNvSpPr/>
                  <p:nvPr/>
                </p:nvSpPr>
                <p:spPr>
                  <a:xfrm>
                    <a:off x="4484520" y="2852640"/>
                    <a:ext cx="5724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2" name="Oval 198"/>
                  <p:cNvSpPr/>
                  <p:nvPr/>
                </p:nvSpPr>
                <p:spPr>
                  <a:xfrm>
                    <a:off x="3968640" y="2881440"/>
                    <a:ext cx="5724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3" name="Oval 199"/>
                  <p:cNvSpPr/>
                  <p:nvPr/>
                </p:nvSpPr>
                <p:spPr>
                  <a:xfrm>
                    <a:off x="4484520" y="2703600"/>
                    <a:ext cx="5724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4" name="Oval 200"/>
                  <p:cNvSpPr/>
                  <p:nvPr/>
                </p:nvSpPr>
                <p:spPr>
                  <a:xfrm>
                    <a:off x="4566960" y="2990880"/>
                    <a:ext cx="5724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45" name="Rectangle 201"/>
                <p:cNvSpPr/>
                <p:nvPr/>
              </p:nvSpPr>
              <p:spPr>
                <a:xfrm>
                  <a:off x="3710880" y="3554280"/>
                  <a:ext cx="1094400" cy="72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360" rIns="90360" tIns="44280" bIns="4428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virus entry</a:t>
                  </a:r>
                  <a:br>
                    <a:rPr sz="1400"/>
                  </a:b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inhibitors</a:t>
                  </a:r>
                  <a:br>
                    <a:rPr sz="1400"/>
                  </a:b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added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46" name="Group 202"/>
                <p:cNvGrpSpPr/>
                <p:nvPr/>
              </p:nvGrpSpPr>
              <p:grpSpPr>
                <a:xfrm>
                  <a:off x="3794040" y="3251160"/>
                  <a:ext cx="884160" cy="298080"/>
                  <a:chOff x="3794040" y="3251160"/>
                  <a:chExt cx="884160" cy="298080"/>
                </a:xfrm>
              </p:grpSpPr>
              <p:sp>
                <p:nvSpPr>
                  <p:cNvPr id="247" name="Line 203"/>
                  <p:cNvSpPr/>
                  <p:nvPr/>
                </p:nvSpPr>
                <p:spPr>
                  <a:xfrm>
                    <a:off x="3794040" y="3411720"/>
                    <a:ext cx="884160" cy="0"/>
                  </a:xfrm>
                  <a:prstGeom prst="line">
                    <a:avLst/>
                  </a:prstGeom>
                  <a:ln w="28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8" name="Line 204"/>
                  <p:cNvSpPr/>
                  <p:nvPr/>
                </p:nvSpPr>
                <p:spPr>
                  <a:xfrm>
                    <a:off x="3805560" y="3251160"/>
                    <a:ext cx="0" cy="149040"/>
                  </a:xfrm>
                  <a:prstGeom prst="line">
                    <a:avLst/>
                  </a:prstGeom>
                  <a:ln w="28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9" name="Line 205"/>
                  <p:cNvSpPr/>
                  <p:nvPr/>
                </p:nvSpPr>
                <p:spPr>
                  <a:xfrm>
                    <a:off x="4264920" y="3400200"/>
                    <a:ext cx="0" cy="149040"/>
                  </a:xfrm>
                  <a:prstGeom prst="line">
                    <a:avLst/>
                  </a:prstGeom>
                  <a:ln w="28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0" name="Line 206"/>
                  <p:cNvSpPr/>
                  <p:nvPr/>
                </p:nvSpPr>
                <p:spPr>
                  <a:xfrm>
                    <a:off x="4668120" y="3251160"/>
                    <a:ext cx="0" cy="149040"/>
                  </a:xfrm>
                  <a:prstGeom prst="line">
                    <a:avLst/>
                  </a:prstGeom>
                  <a:ln w="28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51" name="Line 208"/>
                <p:cNvSpPr/>
                <p:nvPr/>
              </p:nvSpPr>
              <p:spPr>
                <a:xfrm flipV="1">
                  <a:off x="5411520" y="1823400"/>
                  <a:ext cx="0" cy="8492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52" name="Group 209"/>
                <p:cNvGrpSpPr/>
                <p:nvPr/>
              </p:nvGrpSpPr>
              <p:grpSpPr>
                <a:xfrm>
                  <a:off x="2680920" y="1201320"/>
                  <a:ext cx="620640" cy="412200"/>
                  <a:chOff x="2680920" y="1201320"/>
                  <a:chExt cx="620640" cy="412200"/>
                </a:xfrm>
              </p:grpSpPr>
              <p:sp>
                <p:nvSpPr>
                  <p:cNvPr id="253" name="Oval 210"/>
                  <p:cNvSpPr/>
                  <p:nvPr/>
                </p:nvSpPr>
                <p:spPr>
                  <a:xfrm>
                    <a:off x="2680920" y="1218240"/>
                    <a:ext cx="620640" cy="395280"/>
                  </a:xfrm>
                  <a:prstGeom prst="ellipse">
                    <a:avLst/>
                  </a:prstGeom>
                  <a:noFill/>
                  <a:ln w="28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4" name="Rectangle 211"/>
                  <p:cNvSpPr/>
                  <p:nvPr/>
                </p:nvSpPr>
                <p:spPr>
                  <a:xfrm>
                    <a:off x="2852640" y="1201320"/>
                    <a:ext cx="303840" cy="77040"/>
                  </a:xfrm>
                  <a:prstGeom prst="rect">
                    <a:avLst/>
                  </a:prstGeom>
                  <a:gradFill rotWithShape="0">
                    <a:gsLst>
                      <a:gs pos="0">
                        <a:srgbClr val="b14700"/>
                      </a:gs>
                      <a:gs pos="50000">
                        <a:srgbClr val="ff6600"/>
                      </a:gs>
                      <a:gs pos="100000">
                        <a:srgbClr val="b14700"/>
                      </a:gs>
                    </a:gsLst>
                    <a:lin ang="5400000"/>
                  </a:gradFill>
                  <a:ln w="12600">
                    <a:solidFill>
                      <a:srgbClr val="ff66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30240" bIns="302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55" name="Group 213"/>
                <p:cNvGrpSpPr/>
                <p:nvPr/>
              </p:nvGrpSpPr>
              <p:grpSpPr>
                <a:xfrm>
                  <a:off x="3443040" y="1454040"/>
                  <a:ext cx="620640" cy="412200"/>
                  <a:chOff x="3443040" y="1454040"/>
                  <a:chExt cx="620640" cy="412200"/>
                </a:xfrm>
              </p:grpSpPr>
              <p:sp>
                <p:nvSpPr>
                  <p:cNvPr id="256" name="Oval 214"/>
                  <p:cNvSpPr/>
                  <p:nvPr/>
                </p:nvSpPr>
                <p:spPr>
                  <a:xfrm>
                    <a:off x="3443040" y="1470960"/>
                    <a:ext cx="620640" cy="395280"/>
                  </a:xfrm>
                  <a:prstGeom prst="ellipse">
                    <a:avLst/>
                  </a:prstGeom>
                  <a:noFill/>
                  <a:ln w="28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7" name="Rectangle 215"/>
                  <p:cNvSpPr/>
                  <p:nvPr/>
                </p:nvSpPr>
                <p:spPr>
                  <a:xfrm>
                    <a:off x="3614760" y="1454040"/>
                    <a:ext cx="303840" cy="77040"/>
                  </a:xfrm>
                  <a:prstGeom prst="rect">
                    <a:avLst/>
                  </a:prstGeom>
                  <a:gradFill rotWithShape="0">
                    <a:gsLst>
                      <a:gs pos="0">
                        <a:srgbClr val="1a3481"/>
                      </a:gs>
                      <a:gs pos="50000">
                        <a:srgbClr val="3366ff"/>
                      </a:gs>
                      <a:gs pos="100000">
                        <a:srgbClr val="1a3481"/>
                      </a:gs>
                    </a:gsLst>
                    <a:lin ang="5400000"/>
                  </a:gradFill>
                  <a:ln w="12600">
                    <a:solidFill>
                      <a:srgbClr val="000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30240" bIns="302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58" name="Group 218"/>
                <p:cNvGrpSpPr/>
                <p:nvPr/>
              </p:nvGrpSpPr>
              <p:grpSpPr>
                <a:xfrm>
                  <a:off x="3592440" y="948960"/>
                  <a:ext cx="620640" cy="412200"/>
                  <a:chOff x="3592440" y="948960"/>
                  <a:chExt cx="620640" cy="412200"/>
                </a:xfrm>
              </p:grpSpPr>
              <p:sp>
                <p:nvSpPr>
                  <p:cNvPr id="259" name="Oval 219"/>
                  <p:cNvSpPr/>
                  <p:nvPr/>
                </p:nvSpPr>
                <p:spPr>
                  <a:xfrm>
                    <a:off x="3592440" y="965880"/>
                    <a:ext cx="620640" cy="395280"/>
                  </a:xfrm>
                  <a:prstGeom prst="ellipse">
                    <a:avLst/>
                  </a:prstGeom>
                  <a:noFill/>
                  <a:ln w="28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0" name="Rectangle 220"/>
                  <p:cNvSpPr/>
                  <p:nvPr/>
                </p:nvSpPr>
                <p:spPr>
                  <a:xfrm>
                    <a:off x="3764160" y="948960"/>
                    <a:ext cx="303840" cy="77040"/>
                  </a:xfrm>
                  <a:prstGeom prst="rect">
                    <a:avLst/>
                  </a:prstGeom>
                  <a:gradFill rotWithShape="0">
                    <a:gsLst>
                      <a:gs pos="0">
                        <a:srgbClr val="003600"/>
                      </a:gs>
                      <a:gs pos="50000">
                        <a:srgbClr val="00ff00"/>
                      </a:gs>
                      <a:gs pos="100000">
                        <a:srgbClr val="003600"/>
                      </a:gs>
                    </a:gsLst>
                    <a:lin ang="5400000"/>
                  </a:grad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30240" bIns="302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61" name="Line 221"/>
                <p:cNvSpPr/>
                <p:nvPr/>
              </p:nvSpPr>
              <p:spPr>
                <a:xfrm flipH="1">
                  <a:off x="5411520" y="2468520"/>
                  <a:ext cx="1440" cy="85068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2" name="Line 222"/>
                <p:cNvSpPr/>
                <p:nvPr/>
              </p:nvSpPr>
              <p:spPr>
                <a:xfrm>
                  <a:off x="4733640" y="2892240"/>
                  <a:ext cx="601560" cy="144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3" name="Text Box 225"/>
                <p:cNvSpPr/>
                <p:nvPr/>
              </p:nvSpPr>
              <p:spPr>
                <a:xfrm>
                  <a:off x="2412720" y="3759120"/>
                  <a:ext cx="40932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800" spc="-1" strike="noStrike">
                      <a:solidFill>
                        <a:srgbClr val="0000ff"/>
                      </a:solidFill>
                      <a:latin typeface="Arial"/>
                    </a:rPr>
                    <a:t>C.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4" name="Text Box 226"/>
                <p:cNvSpPr/>
                <p:nvPr/>
              </p:nvSpPr>
              <p:spPr>
                <a:xfrm>
                  <a:off x="8028000" y="207360"/>
                  <a:ext cx="40932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800" spc="-1" strike="noStrike">
                      <a:solidFill>
                        <a:srgbClr val="0000ff"/>
                      </a:solidFill>
                      <a:latin typeface="Arial"/>
                    </a:rPr>
                    <a:t>D.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5" name="Text Box 227"/>
                <p:cNvSpPr/>
                <p:nvPr/>
              </p:nvSpPr>
              <p:spPr>
                <a:xfrm>
                  <a:off x="8040600" y="2698560"/>
                  <a:ext cx="39708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800" spc="-1" strike="noStrike">
                      <a:solidFill>
                        <a:srgbClr val="0000ff"/>
                      </a:solidFill>
                      <a:latin typeface="Arial"/>
                    </a:rPr>
                    <a:t>E.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6" name="Text Box 228"/>
                <p:cNvSpPr/>
                <p:nvPr/>
              </p:nvSpPr>
              <p:spPr>
                <a:xfrm>
                  <a:off x="4100400" y="4213440"/>
                  <a:ext cx="384840" cy="3682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800" spc="-1" strike="noStrike">
                      <a:solidFill>
                        <a:srgbClr val="0000ff"/>
                      </a:solidFill>
                      <a:latin typeface="Arial"/>
                    </a:rPr>
                    <a:t>F.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67" name="Group 241"/>
                <p:cNvGrpSpPr/>
                <p:nvPr/>
              </p:nvGrpSpPr>
              <p:grpSpPr>
                <a:xfrm>
                  <a:off x="5122800" y="2374920"/>
                  <a:ext cx="2592360" cy="1887840"/>
                  <a:chOff x="5122800" y="2374920"/>
                  <a:chExt cx="2592360" cy="1887840"/>
                </a:xfrm>
              </p:grpSpPr>
              <p:sp>
                <p:nvSpPr>
                  <p:cNvPr id="268" name="Freeform 35"/>
                  <p:cNvSpPr/>
                  <p:nvPr/>
                </p:nvSpPr>
                <p:spPr>
                  <a:xfrm>
                    <a:off x="5192640" y="2374920"/>
                    <a:ext cx="2522520" cy="1887480"/>
                  </a:xfrm>
                  <a:custGeom>
                    <a:avLst/>
                    <a:gdLst>
                      <a:gd name="textAreaLeft" fmla="*/ 0 w 2522520"/>
                      <a:gd name="textAreaRight" fmla="*/ 2522880 w 2522520"/>
                      <a:gd name="textAreaTop" fmla="*/ 0 h 1887480"/>
                      <a:gd name="textAreaBottom" fmla="*/ 1887840 h 1887480"/>
                    </a:gdLst>
                    <a:ahLst/>
                    <a:rect l="textAreaLeft" t="textAreaTop" r="textAreaRight" b="textAreaBottom"/>
                    <a:pathLst>
                      <a:path w="1761" h="1317">
                        <a:moveTo>
                          <a:pt x="169" y="727"/>
                        </a:moveTo>
                        <a:lnTo>
                          <a:pt x="203" y="717"/>
                        </a:lnTo>
                        <a:lnTo>
                          <a:pt x="235" y="700"/>
                        </a:lnTo>
                        <a:lnTo>
                          <a:pt x="300" y="682"/>
                        </a:lnTo>
                        <a:lnTo>
                          <a:pt x="365" y="665"/>
                        </a:lnTo>
                        <a:lnTo>
                          <a:pt x="430" y="629"/>
                        </a:lnTo>
                        <a:lnTo>
                          <a:pt x="495" y="594"/>
                        </a:lnTo>
                        <a:lnTo>
                          <a:pt x="543" y="559"/>
                        </a:lnTo>
                        <a:lnTo>
                          <a:pt x="597" y="515"/>
                        </a:lnTo>
                        <a:lnTo>
                          <a:pt x="641" y="471"/>
                        </a:lnTo>
                        <a:lnTo>
                          <a:pt x="669" y="453"/>
                        </a:lnTo>
                        <a:lnTo>
                          <a:pt x="706" y="418"/>
                        </a:lnTo>
                        <a:lnTo>
                          <a:pt x="738" y="383"/>
                        </a:lnTo>
                        <a:lnTo>
                          <a:pt x="771" y="348"/>
                        </a:lnTo>
                        <a:lnTo>
                          <a:pt x="835" y="295"/>
                        </a:lnTo>
                        <a:lnTo>
                          <a:pt x="880" y="260"/>
                        </a:lnTo>
                        <a:lnTo>
                          <a:pt x="916" y="224"/>
                        </a:lnTo>
                        <a:lnTo>
                          <a:pt x="970" y="183"/>
                        </a:lnTo>
                        <a:lnTo>
                          <a:pt x="1014" y="154"/>
                        </a:lnTo>
                        <a:lnTo>
                          <a:pt x="1049" y="134"/>
                        </a:lnTo>
                        <a:lnTo>
                          <a:pt x="1090" y="103"/>
                        </a:lnTo>
                        <a:lnTo>
                          <a:pt x="1127" y="84"/>
                        </a:lnTo>
                        <a:lnTo>
                          <a:pt x="1175" y="52"/>
                        </a:lnTo>
                        <a:lnTo>
                          <a:pt x="1246" y="24"/>
                        </a:lnTo>
                        <a:lnTo>
                          <a:pt x="1290" y="13"/>
                        </a:lnTo>
                        <a:lnTo>
                          <a:pt x="1348" y="0"/>
                        </a:lnTo>
                        <a:lnTo>
                          <a:pt x="1381" y="0"/>
                        </a:lnTo>
                        <a:lnTo>
                          <a:pt x="1417" y="0"/>
                        </a:lnTo>
                        <a:lnTo>
                          <a:pt x="1461" y="9"/>
                        </a:lnTo>
                        <a:lnTo>
                          <a:pt x="1516" y="20"/>
                        </a:lnTo>
                        <a:lnTo>
                          <a:pt x="1561" y="35"/>
                        </a:lnTo>
                        <a:lnTo>
                          <a:pt x="1611" y="56"/>
                        </a:lnTo>
                        <a:lnTo>
                          <a:pt x="1663" y="101"/>
                        </a:lnTo>
                        <a:lnTo>
                          <a:pt x="1695" y="136"/>
                        </a:lnTo>
                        <a:lnTo>
                          <a:pt x="1725" y="180"/>
                        </a:lnTo>
                        <a:lnTo>
                          <a:pt x="1744" y="242"/>
                        </a:lnTo>
                        <a:lnTo>
                          <a:pt x="1760" y="312"/>
                        </a:lnTo>
                        <a:lnTo>
                          <a:pt x="1760" y="348"/>
                        </a:lnTo>
                        <a:lnTo>
                          <a:pt x="1760" y="383"/>
                        </a:lnTo>
                        <a:lnTo>
                          <a:pt x="1760" y="418"/>
                        </a:lnTo>
                        <a:lnTo>
                          <a:pt x="1760" y="489"/>
                        </a:lnTo>
                        <a:lnTo>
                          <a:pt x="1756" y="541"/>
                        </a:lnTo>
                        <a:lnTo>
                          <a:pt x="1744" y="612"/>
                        </a:lnTo>
                        <a:lnTo>
                          <a:pt x="1736" y="651"/>
                        </a:lnTo>
                        <a:lnTo>
                          <a:pt x="1720" y="713"/>
                        </a:lnTo>
                        <a:lnTo>
                          <a:pt x="1708" y="757"/>
                        </a:lnTo>
                        <a:lnTo>
                          <a:pt x="1691" y="797"/>
                        </a:lnTo>
                        <a:lnTo>
                          <a:pt x="1675" y="840"/>
                        </a:lnTo>
                        <a:lnTo>
                          <a:pt x="1646" y="893"/>
                        </a:lnTo>
                        <a:lnTo>
                          <a:pt x="1630" y="929"/>
                        </a:lnTo>
                        <a:lnTo>
                          <a:pt x="1614" y="964"/>
                        </a:lnTo>
                        <a:lnTo>
                          <a:pt x="1582" y="1017"/>
                        </a:lnTo>
                        <a:lnTo>
                          <a:pt x="1533" y="1070"/>
                        </a:lnTo>
                        <a:lnTo>
                          <a:pt x="1500" y="1105"/>
                        </a:lnTo>
                        <a:lnTo>
                          <a:pt x="1468" y="1140"/>
                        </a:lnTo>
                        <a:lnTo>
                          <a:pt x="1419" y="1175"/>
                        </a:lnTo>
                        <a:lnTo>
                          <a:pt x="1394" y="1188"/>
                        </a:lnTo>
                        <a:lnTo>
                          <a:pt x="1358" y="1202"/>
                        </a:lnTo>
                        <a:lnTo>
                          <a:pt x="1314" y="1219"/>
                        </a:lnTo>
                        <a:lnTo>
                          <a:pt x="1225" y="1246"/>
                        </a:lnTo>
                        <a:lnTo>
                          <a:pt x="1160" y="1263"/>
                        </a:lnTo>
                        <a:lnTo>
                          <a:pt x="1111" y="1281"/>
                        </a:lnTo>
                        <a:lnTo>
                          <a:pt x="1048" y="1288"/>
                        </a:lnTo>
                        <a:lnTo>
                          <a:pt x="998" y="1298"/>
                        </a:lnTo>
                        <a:lnTo>
                          <a:pt x="949" y="1298"/>
                        </a:lnTo>
                        <a:lnTo>
                          <a:pt x="892" y="1307"/>
                        </a:lnTo>
                        <a:lnTo>
                          <a:pt x="832" y="1307"/>
                        </a:lnTo>
                        <a:lnTo>
                          <a:pt x="771" y="1316"/>
                        </a:lnTo>
                        <a:lnTo>
                          <a:pt x="722" y="1316"/>
                        </a:lnTo>
                        <a:lnTo>
                          <a:pt x="689" y="1316"/>
                        </a:lnTo>
                        <a:lnTo>
                          <a:pt x="608" y="1316"/>
                        </a:lnTo>
                        <a:lnTo>
                          <a:pt x="560" y="1316"/>
                        </a:lnTo>
                        <a:lnTo>
                          <a:pt x="479" y="1316"/>
                        </a:lnTo>
                        <a:lnTo>
                          <a:pt x="430" y="1316"/>
                        </a:lnTo>
                        <a:lnTo>
                          <a:pt x="386" y="1312"/>
                        </a:lnTo>
                        <a:lnTo>
                          <a:pt x="310" y="1294"/>
                        </a:lnTo>
                        <a:lnTo>
                          <a:pt x="284" y="1281"/>
                        </a:lnTo>
                        <a:lnTo>
                          <a:pt x="235" y="1259"/>
                        </a:lnTo>
                        <a:lnTo>
                          <a:pt x="207" y="1241"/>
                        </a:lnTo>
                        <a:lnTo>
                          <a:pt x="170" y="1210"/>
                        </a:lnTo>
                        <a:lnTo>
                          <a:pt x="139" y="1184"/>
                        </a:lnTo>
                        <a:lnTo>
                          <a:pt x="89" y="1140"/>
                        </a:lnTo>
                        <a:lnTo>
                          <a:pt x="57" y="1105"/>
                        </a:lnTo>
                        <a:lnTo>
                          <a:pt x="31" y="1074"/>
                        </a:lnTo>
                        <a:lnTo>
                          <a:pt x="16" y="1043"/>
                        </a:lnTo>
                        <a:lnTo>
                          <a:pt x="0" y="996"/>
                        </a:lnTo>
                        <a:lnTo>
                          <a:pt x="0" y="959"/>
                        </a:lnTo>
                        <a:lnTo>
                          <a:pt x="12" y="911"/>
                        </a:lnTo>
                        <a:lnTo>
                          <a:pt x="24" y="876"/>
                        </a:lnTo>
                        <a:lnTo>
                          <a:pt x="41" y="841"/>
                        </a:lnTo>
                        <a:lnTo>
                          <a:pt x="64" y="814"/>
                        </a:lnTo>
                        <a:lnTo>
                          <a:pt x="89" y="788"/>
                        </a:lnTo>
                        <a:lnTo>
                          <a:pt x="122" y="753"/>
                        </a:lnTo>
                        <a:lnTo>
                          <a:pt x="154" y="735"/>
                        </a:lnTo>
                        <a:lnTo>
                          <a:pt x="157" y="741"/>
                        </a:lnTo>
                        <a:lnTo>
                          <a:pt x="169" y="727"/>
                        </a:lnTo>
                      </a:path>
                    </a:pathLst>
                  </a:custGeom>
                  <a:blipFill rotWithShape="0">
                    <a:blip r:embed="rId3"/>
                    <a:srcRect/>
                    <a:stretch/>
                  </a:blipFill>
                  <a:ln cap="rnd" w="190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269" name="Group 233"/>
                  <p:cNvGrpSpPr/>
                  <p:nvPr/>
                </p:nvGrpSpPr>
                <p:grpSpPr>
                  <a:xfrm>
                    <a:off x="6639840" y="2563560"/>
                    <a:ext cx="1003320" cy="853560"/>
                    <a:chOff x="6639840" y="2563560"/>
                    <a:chExt cx="1003320" cy="853560"/>
                  </a:xfrm>
                </p:grpSpPr>
                <p:sp>
                  <p:nvSpPr>
                    <p:cNvPr id="270" name="Oval 56"/>
                    <p:cNvSpPr/>
                    <p:nvPr/>
                  </p:nvSpPr>
                  <p:spPr>
                    <a:xfrm>
                      <a:off x="7375320" y="3169800"/>
                      <a:ext cx="122040" cy="105840"/>
                    </a:xfrm>
                    <a:prstGeom prst="ellipse">
                      <a:avLst/>
                    </a:prstGeom>
                    <a:solidFill>
                      <a:srgbClr val="fafd00"/>
                    </a:solidFill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28080" bIns="2808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1" name="Line 57"/>
                    <p:cNvSpPr/>
                    <p:nvPr/>
                  </p:nvSpPr>
                  <p:spPr>
                    <a:xfrm>
                      <a:off x="7432560" y="3044160"/>
                      <a:ext cx="0" cy="12672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2" name="Line 58"/>
                    <p:cNvSpPr/>
                    <p:nvPr/>
                  </p:nvSpPr>
                  <p:spPr>
                    <a:xfrm>
                      <a:off x="7432560" y="3290400"/>
                      <a:ext cx="0" cy="12672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3" name="Line 59"/>
                    <p:cNvSpPr/>
                    <p:nvPr/>
                  </p:nvSpPr>
                  <p:spPr>
                    <a:xfrm flipH="1">
                      <a:off x="7505280" y="3231720"/>
                      <a:ext cx="137880" cy="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4" name="Line 60"/>
                    <p:cNvSpPr/>
                    <p:nvPr/>
                  </p:nvSpPr>
                  <p:spPr>
                    <a:xfrm flipH="1">
                      <a:off x="7236720" y="3228480"/>
                      <a:ext cx="136440" cy="108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5" name="Line 61"/>
                    <p:cNvSpPr/>
                    <p:nvPr/>
                  </p:nvSpPr>
                  <p:spPr>
                    <a:xfrm flipH="1">
                      <a:off x="7484760" y="3094920"/>
                      <a:ext cx="106560" cy="8244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5640" bIns="3564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6" name="Line 62"/>
                    <p:cNvSpPr/>
                    <p:nvPr/>
                  </p:nvSpPr>
                  <p:spPr>
                    <a:xfrm flipH="1">
                      <a:off x="7284600" y="3269520"/>
                      <a:ext cx="104760" cy="7920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2400" bIns="324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7" name="Line 63"/>
                    <p:cNvSpPr/>
                    <p:nvPr/>
                  </p:nvSpPr>
                  <p:spPr>
                    <a:xfrm flipH="1" flipV="1">
                      <a:off x="7275240" y="3074400"/>
                      <a:ext cx="115920" cy="11088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8" name="Line 64"/>
                    <p:cNvSpPr/>
                    <p:nvPr/>
                  </p:nvSpPr>
                  <p:spPr>
                    <a:xfrm flipH="1" flipV="1">
                      <a:off x="7480080" y="3261600"/>
                      <a:ext cx="101520" cy="10296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9" name="Oval 65"/>
                    <p:cNvSpPr/>
                    <p:nvPr/>
                  </p:nvSpPr>
                  <p:spPr>
                    <a:xfrm>
                      <a:off x="7238880" y="2699640"/>
                      <a:ext cx="122040" cy="104400"/>
                    </a:xfrm>
                    <a:prstGeom prst="ellipse">
                      <a:avLst/>
                    </a:prstGeom>
                    <a:solidFill>
                      <a:srgbClr val="fafd00"/>
                    </a:solidFill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27360" bIns="2736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0" name="Line 66"/>
                    <p:cNvSpPr/>
                    <p:nvPr/>
                  </p:nvSpPr>
                  <p:spPr>
                    <a:xfrm>
                      <a:off x="7294320" y="2574360"/>
                      <a:ext cx="0" cy="12492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1" name="Line 67"/>
                    <p:cNvSpPr/>
                    <p:nvPr/>
                  </p:nvSpPr>
                  <p:spPr>
                    <a:xfrm>
                      <a:off x="7294320" y="2820600"/>
                      <a:ext cx="0" cy="12636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2" name="Line 68"/>
                    <p:cNvSpPr/>
                    <p:nvPr/>
                  </p:nvSpPr>
                  <p:spPr>
                    <a:xfrm flipH="1">
                      <a:off x="7367400" y="2760120"/>
                      <a:ext cx="139680" cy="108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3" name="Line 69"/>
                    <p:cNvSpPr/>
                    <p:nvPr/>
                  </p:nvSpPr>
                  <p:spPr>
                    <a:xfrm flipH="1">
                      <a:off x="7098840" y="2758680"/>
                      <a:ext cx="136440" cy="108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4" name="Line 70"/>
                    <p:cNvSpPr/>
                    <p:nvPr/>
                  </p:nvSpPr>
                  <p:spPr>
                    <a:xfrm flipH="1">
                      <a:off x="7346520" y="2625120"/>
                      <a:ext cx="106200" cy="8208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5280" bIns="3528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5" name="Line 71"/>
                    <p:cNvSpPr/>
                    <p:nvPr/>
                  </p:nvSpPr>
                  <p:spPr>
                    <a:xfrm flipH="1">
                      <a:off x="7146360" y="2799720"/>
                      <a:ext cx="104760" cy="7920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2400" bIns="324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6" name="Line 72"/>
                    <p:cNvSpPr/>
                    <p:nvPr/>
                  </p:nvSpPr>
                  <p:spPr>
                    <a:xfrm flipH="1" flipV="1">
                      <a:off x="7138440" y="2604240"/>
                      <a:ext cx="114120" cy="11052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7" name="Line 73"/>
                    <p:cNvSpPr/>
                    <p:nvPr/>
                  </p:nvSpPr>
                  <p:spPr>
                    <a:xfrm flipH="1" flipV="1">
                      <a:off x="7341480" y="2790360"/>
                      <a:ext cx="101880" cy="10440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8" name="Oval 74"/>
                    <p:cNvSpPr/>
                    <p:nvPr/>
                  </p:nvSpPr>
                  <p:spPr>
                    <a:xfrm>
                      <a:off x="6779880" y="3020400"/>
                      <a:ext cx="122400" cy="106200"/>
                    </a:xfrm>
                    <a:prstGeom prst="ellipse">
                      <a:avLst/>
                    </a:prstGeom>
                    <a:solidFill>
                      <a:srgbClr val="fafd00"/>
                    </a:solidFill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28440" bIns="2844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9" name="Line 75"/>
                    <p:cNvSpPr/>
                    <p:nvPr/>
                  </p:nvSpPr>
                  <p:spPr>
                    <a:xfrm>
                      <a:off x="6835680" y="2895120"/>
                      <a:ext cx="0" cy="12672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0" name="Line 76"/>
                    <p:cNvSpPr/>
                    <p:nvPr/>
                  </p:nvSpPr>
                  <p:spPr>
                    <a:xfrm>
                      <a:off x="6835680" y="3142800"/>
                      <a:ext cx="0" cy="12492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1" name="Line 77"/>
                    <p:cNvSpPr/>
                    <p:nvPr/>
                  </p:nvSpPr>
                  <p:spPr>
                    <a:xfrm flipH="1">
                      <a:off x="6908040" y="3082320"/>
                      <a:ext cx="140040" cy="144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360" bIns="-4536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2" name="Line 78"/>
                    <p:cNvSpPr/>
                    <p:nvPr/>
                  </p:nvSpPr>
                  <p:spPr>
                    <a:xfrm flipH="1">
                      <a:off x="6639840" y="3079080"/>
                      <a:ext cx="136440" cy="144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360" bIns="-4536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3" name="Line 79"/>
                    <p:cNvSpPr/>
                    <p:nvPr/>
                  </p:nvSpPr>
                  <p:spPr>
                    <a:xfrm flipH="1">
                      <a:off x="6889320" y="2945880"/>
                      <a:ext cx="104760" cy="8208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5280" bIns="3528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4" name="Line 80"/>
                    <p:cNvSpPr/>
                    <p:nvPr/>
                  </p:nvSpPr>
                  <p:spPr>
                    <a:xfrm flipH="1">
                      <a:off x="6687720" y="3120480"/>
                      <a:ext cx="105120" cy="8064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3840" bIns="3384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5" name="Line 81"/>
                    <p:cNvSpPr/>
                    <p:nvPr/>
                  </p:nvSpPr>
                  <p:spPr>
                    <a:xfrm flipH="1" flipV="1">
                      <a:off x="6679800" y="2925000"/>
                      <a:ext cx="114480" cy="11052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6" name="Line 82"/>
                    <p:cNvSpPr/>
                    <p:nvPr/>
                  </p:nvSpPr>
                  <p:spPr>
                    <a:xfrm flipH="1" flipV="1">
                      <a:off x="6883200" y="3112560"/>
                      <a:ext cx="101520" cy="10440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7" name="Oval 83"/>
                    <p:cNvSpPr/>
                    <p:nvPr/>
                  </p:nvSpPr>
                  <p:spPr>
                    <a:xfrm>
                      <a:off x="6848280" y="2687040"/>
                      <a:ext cx="122040" cy="106200"/>
                    </a:xfrm>
                    <a:prstGeom prst="ellipse">
                      <a:avLst/>
                    </a:prstGeom>
                    <a:solidFill>
                      <a:srgbClr val="fafd00"/>
                    </a:solidFill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28440" bIns="2844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8" name="Line 84"/>
                    <p:cNvSpPr/>
                    <p:nvPr/>
                  </p:nvSpPr>
                  <p:spPr>
                    <a:xfrm>
                      <a:off x="6903720" y="2563560"/>
                      <a:ext cx="0" cy="12528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9" name="Line 85"/>
                    <p:cNvSpPr/>
                    <p:nvPr/>
                  </p:nvSpPr>
                  <p:spPr>
                    <a:xfrm>
                      <a:off x="6903720" y="2809440"/>
                      <a:ext cx="0" cy="12636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0" name="Line 86"/>
                    <p:cNvSpPr/>
                    <p:nvPr/>
                  </p:nvSpPr>
                  <p:spPr>
                    <a:xfrm flipH="1">
                      <a:off x="6978240" y="2748960"/>
                      <a:ext cx="138240" cy="144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360" bIns="-4536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1" name="Line 87"/>
                    <p:cNvSpPr/>
                    <p:nvPr/>
                  </p:nvSpPr>
                  <p:spPr>
                    <a:xfrm flipH="1">
                      <a:off x="6709680" y="2745720"/>
                      <a:ext cx="135000" cy="144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360" bIns="-4536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2" name="Line 88"/>
                    <p:cNvSpPr/>
                    <p:nvPr/>
                  </p:nvSpPr>
                  <p:spPr>
                    <a:xfrm flipH="1">
                      <a:off x="6957720" y="2612520"/>
                      <a:ext cx="106560" cy="8388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7080" bIns="3708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3" name="Line 89"/>
                    <p:cNvSpPr/>
                    <p:nvPr/>
                  </p:nvSpPr>
                  <p:spPr>
                    <a:xfrm flipH="1">
                      <a:off x="6755760" y="2788560"/>
                      <a:ext cx="104760" cy="7920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2400" bIns="324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4" name="Line 90"/>
                    <p:cNvSpPr/>
                    <p:nvPr/>
                  </p:nvSpPr>
                  <p:spPr>
                    <a:xfrm flipH="1" flipV="1">
                      <a:off x="6748200" y="2593080"/>
                      <a:ext cx="114480" cy="10908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5" name="Line 91"/>
                    <p:cNvSpPr/>
                    <p:nvPr/>
                  </p:nvSpPr>
                  <p:spPr>
                    <a:xfrm flipH="1" flipV="1">
                      <a:off x="6951600" y="2779200"/>
                      <a:ext cx="101520" cy="10440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306" name="Group 232"/>
                  <p:cNvGrpSpPr/>
                  <p:nvPr/>
                </p:nvGrpSpPr>
                <p:grpSpPr>
                  <a:xfrm>
                    <a:off x="5538600" y="3147840"/>
                    <a:ext cx="890640" cy="670320"/>
                    <a:chOff x="5538600" y="3147840"/>
                    <a:chExt cx="890640" cy="670320"/>
                  </a:xfrm>
                </p:grpSpPr>
                <p:sp>
                  <p:nvSpPr>
                    <p:cNvPr id="307" name="Oval 92"/>
                    <p:cNvSpPr/>
                    <p:nvPr/>
                  </p:nvSpPr>
                  <p:spPr>
                    <a:xfrm>
                      <a:off x="6160680" y="3272760"/>
                      <a:ext cx="122400" cy="106200"/>
                    </a:xfrm>
                    <a:prstGeom prst="ellipse">
                      <a:avLst/>
                    </a:prstGeom>
                    <a:solidFill>
                      <a:srgbClr val="fafd00"/>
                    </a:solidFill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28440" bIns="2844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8" name="Line 93"/>
                    <p:cNvSpPr/>
                    <p:nvPr/>
                  </p:nvSpPr>
                  <p:spPr>
                    <a:xfrm>
                      <a:off x="6216480" y="3147840"/>
                      <a:ext cx="0" cy="12672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9" name="Line 95"/>
                    <p:cNvSpPr/>
                    <p:nvPr/>
                  </p:nvSpPr>
                  <p:spPr>
                    <a:xfrm flipH="1">
                      <a:off x="6289560" y="3334680"/>
                      <a:ext cx="139680" cy="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0" name="Line 97"/>
                    <p:cNvSpPr/>
                    <p:nvPr/>
                  </p:nvSpPr>
                  <p:spPr>
                    <a:xfrm flipH="1">
                      <a:off x="6268680" y="3198240"/>
                      <a:ext cx="106560" cy="8208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5280" bIns="3528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1" name="Line 99"/>
                    <p:cNvSpPr/>
                    <p:nvPr/>
                  </p:nvSpPr>
                  <p:spPr>
                    <a:xfrm flipH="1" flipV="1">
                      <a:off x="6060600" y="3177360"/>
                      <a:ext cx="114120" cy="110520"/>
                    </a:xfrm>
                    <a:prstGeom prst="line">
                      <a:avLst/>
                    </a:prstGeom>
                    <a:ln w="12600">
                      <a:solidFill>
                        <a:srgbClr val="ffdc44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grpSp>
                  <p:nvGrpSpPr>
                    <p:cNvPr id="312" name="Group 231"/>
                    <p:cNvGrpSpPr/>
                    <p:nvPr/>
                  </p:nvGrpSpPr>
                  <p:grpSpPr>
                    <a:xfrm>
                      <a:off x="5538600" y="3331440"/>
                      <a:ext cx="826920" cy="486720"/>
                      <a:chOff x="5538600" y="3331440"/>
                      <a:chExt cx="826920" cy="486720"/>
                    </a:xfrm>
                  </p:grpSpPr>
                  <p:sp>
                    <p:nvSpPr>
                      <p:cNvPr id="313" name="Oval 38"/>
                      <p:cNvSpPr/>
                      <p:nvPr/>
                    </p:nvSpPr>
                    <p:spPr>
                      <a:xfrm>
                        <a:off x="6022800" y="3570840"/>
                        <a:ext cx="122040" cy="104400"/>
                      </a:xfrm>
                      <a:prstGeom prst="ellipse">
                        <a:avLst/>
                      </a:prstGeom>
                      <a:solidFill>
                        <a:srgbClr val="ffff00"/>
                      </a:solidFill>
                      <a:ln w="12600">
                        <a:solidFill>
                          <a:srgbClr val="ffdc44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27360" bIns="27360" anchor="ctr">
                        <a:no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14" name="Line 39"/>
                      <p:cNvSpPr/>
                      <p:nvPr/>
                    </p:nvSpPr>
                    <p:spPr>
                      <a:xfrm>
                        <a:off x="6078240" y="3445560"/>
                        <a:ext cx="0" cy="124920"/>
                      </a:xfrm>
                      <a:prstGeom prst="line">
                        <a:avLst/>
                      </a:prstGeom>
                      <a:ln w="12600">
                        <a:solidFill>
                          <a:srgbClr val="ffdc44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15" name="Line 40"/>
                      <p:cNvSpPr/>
                      <p:nvPr/>
                    </p:nvSpPr>
                    <p:spPr>
                      <a:xfrm>
                        <a:off x="6078240" y="3691440"/>
                        <a:ext cx="0" cy="126720"/>
                      </a:xfrm>
                      <a:prstGeom prst="line">
                        <a:avLst/>
                      </a:prstGeom>
                      <a:ln w="12600">
                        <a:solidFill>
                          <a:srgbClr val="ffdc44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16" name="Line 41"/>
                      <p:cNvSpPr/>
                      <p:nvPr/>
                    </p:nvSpPr>
                    <p:spPr>
                      <a:xfrm flipH="1">
                        <a:off x="6151320" y="3631320"/>
                        <a:ext cx="139680" cy="1080"/>
                      </a:xfrm>
                      <a:prstGeom prst="line">
                        <a:avLst/>
                      </a:prstGeom>
                      <a:ln w="12600">
                        <a:solidFill>
                          <a:srgbClr val="ffdc44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720" bIns="-4572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17" name="Line 42"/>
                      <p:cNvSpPr/>
                      <p:nvPr/>
                    </p:nvSpPr>
                    <p:spPr>
                      <a:xfrm flipH="1">
                        <a:off x="5884200" y="3629520"/>
                        <a:ext cx="135000" cy="0"/>
                      </a:xfrm>
                      <a:prstGeom prst="line">
                        <a:avLst/>
                      </a:prstGeom>
                      <a:ln w="12600">
                        <a:solidFill>
                          <a:srgbClr val="ffff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800" bIns="-468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18" name="Line 43"/>
                      <p:cNvSpPr/>
                      <p:nvPr/>
                    </p:nvSpPr>
                    <p:spPr>
                      <a:xfrm flipH="1">
                        <a:off x="6132240" y="3496320"/>
                        <a:ext cx="106560" cy="82080"/>
                      </a:xfrm>
                      <a:prstGeom prst="line">
                        <a:avLst/>
                      </a:prstGeom>
                      <a:ln w="12600">
                        <a:solidFill>
                          <a:srgbClr val="ffdc44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35280" bIns="3528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19" name="Line 44"/>
                      <p:cNvSpPr/>
                      <p:nvPr/>
                    </p:nvSpPr>
                    <p:spPr>
                      <a:xfrm flipH="1">
                        <a:off x="5930280" y="3670920"/>
                        <a:ext cx="104760" cy="79200"/>
                      </a:xfrm>
                      <a:prstGeom prst="line">
                        <a:avLst/>
                      </a:prstGeom>
                      <a:ln w="12600">
                        <a:solidFill>
                          <a:srgbClr val="ffff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32400" bIns="324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20" name="Line 45"/>
                      <p:cNvSpPr/>
                      <p:nvPr/>
                    </p:nvSpPr>
                    <p:spPr>
                      <a:xfrm flipH="1" flipV="1">
                        <a:off x="5922720" y="3475440"/>
                        <a:ext cx="114480" cy="109080"/>
                      </a:xfrm>
                      <a:prstGeom prst="line">
                        <a:avLst/>
                      </a:prstGeom>
                      <a:ln w="12600">
                        <a:solidFill>
                          <a:srgbClr val="ffff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21" name="Line 46"/>
                      <p:cNvSpPr/>
                      <p:nvPr/>
                    </p:nvSpPr>
                    <p:spPr>
                      <a:xfrm flipH="1" flipV="1">
                        <a:off x="6125400" y="3661560"/>
                        <a:ext cx="101880" cy="104400"/>
                      </a:xfrm>
                      <a:prstGeom prst="line">
                        <a:avLst/>
                      </a:prstGeom>
                      <a:ln w="12600">
                        <a:solidFill>
                          <a:srgbClr val="ffdc44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22" name="Oval 47"/>
                      <p:cNvSpPr/>
                      <p:nvPr/>
                    </p:nvSpPr>
                    <p:spPr>
                      <a:xfrm>
                        <a:off x="5690880" y="3524760"/>
                        <a:ext cx="120600" cy="104400"/>
                      </a:xfrm>
                      <a:prstGeom prst="ellipse">
                        <a:avLst/>
                      </a:prstGeom>
                      <a:solidFill>
                        <a:srgbClr val="ffff00"/>
                      </a:solidFill>
                      <a:ln w="12600">
                        <a:solidFill>
                          <a:srgbClr val="ffff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27360" bIns="27360" anchor="ctr">
                        <a:no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23" name="Line 48"/>
                      <p:cNvSpPr/>
                      <p:nvPr/>
                    </p:nvSpPr>
                    <p:spPr>
                      <a:xfrm>
                        <a:off x="5746680" y="3399480"/>
                        <a:ext cx="0" cy="126720"/>
                      </a:xfrm>
                      <a:prstGeom prst="line">
                        <a:avLst/>
                      </a:prstGeom>
                      <a:ln w="12600">
                        <a:solidFill>
                          <a:srgbClr val="ffff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24" name="Line 49"/>
                      <p:cNvSpPr/>
                      <p:nvPr/>
                    </p:nvSpPr>
                    <p:spPr>
                      <a:xfrm>
                        <a:off x="5746680" y="3645720"/>
                        <a:ext cx="0" cy="126360"/>
                      </a:xfrm>
                      <a:prstGeom prst="line">
                        <a:avLst/>
                      </a:prstGeom>
                      <a:ln w="12600">
                        <a:solidFill>
                          <a:srgbClr val="ffff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25" name="Line 50"/>
                      <p:cNvSpPr/>
                      <p:nvPr/>
                    </p:nvSpPr>
                    <p:spPr>
                      <a:xfrm flipH="1">
                        <a:off x="5819400" y="3585240"/>
                        <a:ext cx="139680" cy="1080"/>
                      </a:xfrm>
                      <a:prstGeom prst="line">
                        <a:avLst/>
                      </a:prstGeom>
                      <a:ln w="12600">
                        <a:solidFill>
                          <a:srgbClr val="ffff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720" bIns="-4572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26" name="Line 51"/>
                      <p:cNvSpPr/>
                      <p:nvPr/>
                    </p:nvSpPr>
                    <p:spPr>
                      <a:xfrm flipH="1">
                        <a:off x="5538600" y="3583800"/>
                        <a:ext cx="149040" cy="0"/>
                      </a:xfrm>
                      <a:prstGeom prst="line">
                        <a:avLst/>
                      </a:prstGeom>
                      <a:ln w="12600">
                        <a:solidFill>
                          <a:srgbClr val="ffff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800" bIns="-468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27" name="Line 52"/>
                      <p:cNvSpPr/>
                      <p:nvPr/>
                    </p:nvSpPr>
                    <p:spPr>
                      <a:xfrm flipH="1">
                        <a:off x="5798880" y="3450240"/>
                        <a:ext cx="106560" cy="82440"/>
                      </a:xfrm>
                      <a:prstGeom prst="line">
                        <a:avLst/>
                      </a:prstGeom>
                      <a:ln w="12600">
                        <a:solidFill>
                          <a:srgbClr val="ffff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35640" bIns="3564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28" name="Line 53"/>
                      <p:cNvSpPr/>
                      <p:nvPr/>
                    </p:nvSpPr>
                    <p:spPr>
                      <a:xfrm flipH="1">
                        <a:off x="5598360" y="3624840"/>
                        <a:ext cx="104760" cy="79200"/>
                      </a:xfrm>
                      <a:prstGeom prst="line">
                        <a:avLst/>
                      </a:prstGeom>
                      <a:ln w="12600">
                        <a:solidFill>
                          <a:srgbClr val="ffff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32400" bIns="324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29" name="Line 54"/>
                      <p:cNvSpPr/>
                      <p:nvPr/>
                    </p:nvSpPr>
                    <p:spPr>
                      <a:xfrm flipH="1" flipV="1">
                        <a:off x="5590800" y="3429720"/>
                        <a:ext cx="114480" cy="110880"/>
                      </a:xfrm>
                      <a:prstGeom prst="line">
                        <a:avLst/>
                      </a:prstGeom>
                      <a:ln w="12600">
                        <a:solidFill>
                          <a:srgbClr val="ffff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30" name="Line 55"/>
                      <p:cNvSpPr/>
                      <p:nvPr/>
                    </p:nvSpPr>
                    <p:spPr>
                      <a:xfrm flipH="1" flipV="1">
                        <a:off x="5794200" y="3615480"/>
                        <a:ext cx="101520" cy="104400"/>
                      </a:xfrm>
                      <a:prstGeom prst="line">
                        <a:avLst/>
                      </a:prstGeom>
                      <a:ln w="12600">
                        <a:solidFill>
                          <a:srgbClr val="ffff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31" name="Line 94"/>
                      <p:cNvSpPr/>
                      <p:nvPr/>
                    </p:nvSpPr>
                    <p:spPr>
                      <a:xfrm>
                        <a:off x="6216480" y="3393000"/>
                        <a:ext cx="0" cy="126720"/>
                      </a:xfrm>
                      <a:prstGeom prst="line">
                        <a:avLst/>
                      </a:prstGeom>
                      <a:ln w="12600">
                        <a:solidFill>
                          <a:srgbClr val="ffdc44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32" name="Line 96"/>
                      <p:cNvSpPr/>
                      <p:nvPr/>
                    </p:nvSpPr>
                    <p:spPr>
                      <a:xfrm flipH="1">
                        <a:off x="6021000" y="3331440"/>
                        <a:ext cx="136800" cy="1440"/>
                      </a:xfrm>
                      <a:prstGeom prst="line">
                        <a:avLst/>
                      </a:prstGeom>
                      <a:ln w="12600">
                        <a:solidFill>
                          <a:srgbClr val="ffdc44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360" bIns="-4536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33" name="Line 98"/>
                      <p:cNvSpPr/>
                      <p:nvPr/>
                    </p:nvSpPr>
                    <p:spPr>
                      <a:xfrm flipH="1">
                        <a:off x="6068520" y="3372480"/>
                        <a:ext cx="104760" cy="80640"/>
                      </a:xfrm>
                      <a:prstGeom prst="line">
                        <a:avLst/>
                      </a:prstGeom>
                      <a:ln w="12600">
                        <a:solidFill>
                          <a:srgbClr val="ffdc44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33840" bIns="3384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334" name="Line 100"/>
                      <p:cNvSpPr/>
                      <p:nvPr/>
                    </p:nvSpPr>
                    <p:spPr>
                      <a:xfrm flipH="1" flipV="1">
                        <a:off x="6264000" y="3364560"/>
                        <a:ext cx="101520" cy="102960"/>
                      </a:xfrm>
                      <a:prstGeom prst="line">
                        <a:avLst/>
                      </a:prstGeom>
                      <a:ln w="12600">
                        <a:solidFill>
                          <a:srgbClr val="ffdc44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</p:grpSp>
              <p:grpSp>
                <p:nvGrpSpPr>
                  <p:cNvPr id="335" name="Group 234"/>
                  <p:cNvGrpSpPr/>
                  <p:nvPr/>
                </p:nvGrpSpPr>
                <p:grpSpPr>
                  <a:xfrm>
                    <a:off x="6082560" y="3092760"/>
                    <a:ext cx="1375920" cy="1170000"/>
                    <a:chOff x="6082560" y="3092760"/>
                    <a:chExt cx="1375920" cy="1170000"/>
                  </a:xfrm>
                </p:grpSpPr>
                <p:sp>
                  <p:nvSpPr>
                    <p:cNvPr id="336" name="Oval 37"/>
                    <p:cNvSpPr/>
                    <p:nvPr/>
                  </p:nvSpPr>
                  <p:spPr>
                    <a:xfrm rot="19680000">
                      <a:off x="6146640" y="3377880"/>
                      <a:ext cx="1247760" cy="599760"/>
                    </a:xfrm>
                    <a:prstGeom prst="ellipse">
                      <a:avLst/>
                    </a:prstGeom>
                    <a:gradFill rotWithShape="0">
                      <a:gsLst>
                        <a:gs pos="0">
                          <a:srgbClr val="cc99ff"/>
                        </a:gs>
                        <a:gs pos="100000">
                          <a:srgbClr val="5e4776"/>
                        </a:gs>
                      </a:gsLst>
                      <a:path path="rect">
                        <a:fillToRect l="50000" t="50000" r="50000" b="50000"/>
                      </a:path>
                    </a:gradFill>
                    <a:ln w="19080">
                      <a:solidFill>
                        <a:srgbClr val="bbe0e3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7" name="Freeform 104"/>
                    <p:cNvSpPr/>
                    <p:nvPr/>
                  </p:nvSpPr>
                  <p:spPr>
                    <a:xfrm>
                      <a:off x="6384600" y="3709440"/>
                      <a:ext cx="150840" cy="139320"/>
                    </a:xfrm>
                    <a:custGeom>
                      <a:avLst/>
                      <a:gdLst>
                        <a:gd name="textAreaLeft" fmla="*/ 0 w 150840"/>
                        <a:gd name="textAreaRight" fmla="*/ 151200 w 150840"/>
                        <a:gd name="textAreaTop" fmla="*/ 0 h 139320"/>
                        <a:gd name="textAreaBottom" fmla="*/ 139680 h 139320"/>
                      </a:gdLst>
                      <a:ahLst/>
                      <a:rect l="textAreaLeft" t="textAreaTop" r="textAreaRight" b="textAreaBottom"/>
                      <a:pathLst>
                        <a:path w="105" h="97">
                          <a:moveTo>
                            <a:pt x="104" y="0"/>
                          </a:moveTo>
                          <a:lnTo>
                            <a:pt x="88" y="0"/>
                          </a:lnTo>
                          <a:lnTo>
                            <a:pt x="72" y="0"/>
                          </a:lnTo>
                          <a:lnTo>
                            <a:pt x="64" y="16"/>
                          </a:lnTo>
                          <a:lnTo>
                            <a:pt x="56" y="32"/>
                          </a:lnTo>
                          <a:lnTo>
                            <a:pt x="56" y="48"/>
                          </a:lnTo>
                          <a:lnTo>
                            <a:pt x="56" y="64"/>
                          </a:lnTo>
                          <a:lnTo>
                            <a:pt x="56" y="80"/>
                          </a:lnTo>
                          <a:lnTo>
                            <a:pt x="48" y="96"/>
                          </a:lnTo>
                          <a:lnTo>
                            <a:pt x="32" y="96"/>
                          </a:lnTo>
                          <a:lnTo>
                            <a:pt x="16" y="96"/>
                          </a:lnTo>
                          <a:lnTo>
                            <a:pt x="8" y="80"/>
                          </a:lnTo>
                          <a:lnTo>
                            <a:pt x="0" y="80"/>
                          </a:lnTo>
                          <a:lnTo>
                            <a:pt x="0" y="80"/>
                          </a:lnTo>
                        </a:path>
                      </a:pathLst>
                    </a:custGeom>
                    <a:noFill/>
                    <a:ln cap="rnd" w="28440">
                      <a:solidFill>
                        <a:srgbClr val="000000"/>
                      </a:solidFill>
                      <a:round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8" name="Freeform 105"/>
                    <p:cNvSpPr/>
                    <p:nvPr/>
                  </p:nvSpPr>
                  <p:spPr>
                    <a:xfrm>
                      <a:off x="7049880" y="3571200"/>
                      <a:ext cx="138240" cy="129960"/>
                    </a:xfrm>
                    <a:custGeom>
                      <a:avLst/>
                      <a:gdLst>
                        <a:gd name="textAreaLeft" fmla="*/ 0 w 138240"/>
                        <a:gd name="textAreaRight" fmla="*/ 138600 w 138240"/>
                        <a:gd name="textAreaTop" fmla="*/ 0 h 129960"/>
                        <a:gd name="textAreaBottom" fmla="*/ 130320 h 129960"/>
                      </a:gdLst>
                      <a:ahLst/>
                      <a:rect l="textAreaLeft" t="textAreaTop" r="textAreaRight" b="textAreaBottom"/>
                      <a:pathLst>
                        <a:path w="105" h="97">
                          <a:moveTo>
                            <a:pt x="104" y="0"/>
                          </a:moveTo>
                          <a:lnTo>
                            <a:pt x="88" y="0"/>
                          </a:lnTo>
                          <a:lnTo>
                            <a:pt x="72" y="0"/>
                          </a:lnTo>
                          <a:lnTo>
                            <a:pt x="64" y="16"/>
                          </a:lnTo>
                          <a:lnTo>
                            <a:pt x="56" y="32"/>
                          </a:lnTo>
                          <a:lnTo>
                            <a:pt x="56" y="48"/>
                          </a:lnTo>
                          <a:lnTo>
                            <a:pt x="56" y="64"/>
                          </a:lnTo>
                          <a:lnTo>
                            <a:pt x="56" y="80"/>
                          </a:lnTo>
                          <a:lnTo>
                            <a:pt x="48" y="96"/>
                          </a:lnTo>
                          <a:lnTo>
                            <a:pt x="32" y="96"/>
                          </a:lnTo>
                          <a:lnTo>
                            <a:pt x="16" y="96"/>
                          </a:lnTo>
                          <a:lnTo>
                            <a:pt x="8" y="80"/>
                          </a:lnTo>
                          <a:lnTo>
                            <a:pt x="0" y="80"/>
                          </a:lnTo>
                          <a:lnTo>
                            <a:pt x="0" y="80"/>
                          </a:lnTo>
                        </a:path>
                      </a:pathLst>
                    </a:custGeom>
                    <a:noFill/>
                    <a:ln cap="rnd" w="28440">
                      <a:solidFill>
                        <a:srgbClr val="000000"/>
                      </a:solidFill>
                      <a:round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9" name="Line 106"/>
                    <p:cNvSpPr/>
                    <p:nvPr/>
                  </p:nvSpPr>
                  <p:spPr>
                    <a:xfrm>
                      <a:off x="6608520" y="3698280"/>
                      <a:ext cx="384120" cy="0"/>
                    </a:xfrm>
                    <a:prstGeom prst="line">
                      <a:avLst/>
                    </a:prstGeom>
                    <a:ln w="28440">
                      <a:solidFill>
                        <a:srgbClr val="ff0066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0" name="Rectangle 107"/>
                    <p:cNvSpPr/>
                    <p:nvPr/>
                  </p:nvSpPr>
                  <p:spPr>
                    <a:xfrm>
                      <a:off x="6980040" y="3669840"/>
                      <a:ext cx="63360" cy="67680"/>
                    </a:xfrm>
                    <a:prstGeom prst="rect">
                      <a:avLst/>
                    </a:prstGeom>
                    <a:solidFill>
                      <a:srgbClr val="5f5f5f"/>
                    </a:solidFill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20880" bIns="2088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1" name="Rectangle 108"/>
                    <p:cNvSpPr/>
                    <p:nvPr/>
                  </p:nvSpPr>
                  <p:spPr>
                    <a:xfrm>
                      <a:off x="6538680" y="3669840"/>
                      <a:ext cx="65160" cy="67680"/>
                    </a:xfrm>
                    <a:prstGeom prst="rect">
                      <a:avLst/>
                    </a:prstGeom>
                    <a:solidFill>
                      <a:srgbClr val="5f5f5f"/>
                    </a:solidFill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20880" bIns="2088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342" name="Group 230"/>
                  <p:cNvGrpSpPr/>
                  <p:nvPr/>
                </p:nvGrpSpPr>
                <p:grpSpPr>
                  <a:xfrm>
                    <a:off x="5122800" y="3584520"/>
                    <a:ext cx="436320" cy="491400"/>
                    <a:chOff x="5122800" y="3584520"/>
                    <a:chExt cx="436320" cy="491400"/>
                  </a:xfrm>
                </p:grpSpPr>
                <p:sp>
                  <p:nvSpPr>
                    <p:cNvPr id="343" name="Oval 36"/>
                    <p:cNvSpPr/>
                    <p:nvPr/>
                  </p:nvSpPr>
                  <p:spPr>
                    <a:xfrm>
                      <a:off x="5317920" y="3893760"/>
                      <a:ext cx="57240" cy="56520"/>
                    </a:xfrm>
                    <a:prstGeom prst="ellipse">
                      <a:avLst/>
                    </a:prstGeom>
                    <a:solidFill>
                      <a:srgbClr val="ffff00"/>
                    </a:solidFill>
                    <a:ln w="25560">
                      <a:solidFill>
                        <a:srgbClr val="660066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-6840" bIns="-684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4" name="Oval 101"/>
                    <p:cNvSpPr/>
                    <p:nvPr/>
                  </p:nvSpPr>
                  <p:spPr>
                    <a:xfrm>
                      <a:off x="5375160" y="4007880"/>
                      <a:ext cx="56880" cy="56880"/>
                    </a:xfrm>
                    <a:prstGeom prst="ellipse">
                      <a:avLst/>
                    </a:prstGeom>
                    <a:solidFill>
                      <a:srgbClr val="ffff00"/>
                    </a:solidFill>
                    <a:ln w="25560">
                      <a:solidFill>
                        <a:srgbClr val="660066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-6480" bIns="-648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5" name="Oval 102"/>
                    <p:cNvSpPr/>
                    <p:nvPr/>
                  </p:nvSpPr>
                  <p:spPr>
                    <a:xfrm>
                      <a:off x="5501880" y="4019040"/>
                      <a:ext cx="57240" cy="56880"/>
                    </a:xfrm>
                    <a:prstGeom prst="ellipse">
                      <a:avLst/>
                    </a:prstGeom>
                    <a:solidFill>
                      <a:srgbClr val="ffff00"/>
                    </a:solidFill>
                    <a:ln w="25560">
                      <a:solidFill>
                        <a:srgbClr val="660066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-6480" bIns="-648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6" name="Oval 109"/>
                    <p:cNvSpPr/>
                    <p:nvPr/>
                  </p:nvSpPr>
                  <p:spPr>
                    <a:xfrm>
                      <a:off x="5157720" y="3584520"/>
                      <a:ext cx="56880" cy="56520"/>
                    </a:xfrm>
                    <a:prstGeom prst="ellipse">
                      <a:avLst/>
                    </a:prstGeom>
                    <a:solidFill>
                      <a:srgbClr val="ffff00"/>
                    </a:solidFill>
                    <a:ln w="25560">
                      <a:solidFill>
                        <a:srgbClr val="660066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-6840" bIns="-684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7" name="Oval 207"/>
                    <p:cNvSpPr/>
                    <p:nvPr/>
                  </p:nvSpPr>
                  <p:spPr>
                    <a:xfrm>
                      <a:off x="5122800" y="3744360"/>
                      <a:ext cx="56880" cy="56880"/>
                    </a:xfrm>
                    <a:prstGeom prst="ellipse">
                      <a:avLst/>
                    </a:prstGeom>
                    <a:solidFill>
                      <a:srgbClr val="ffff00"/>
                    </a:solidFill>
                    <a:ln w="25560">
                      <a:solidFill>
                        <a:srgbClr val="660066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-6480" bIns="-648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sp>
              <p:nvSpPr>
                <p:cNvPr id="348" name="Line 103"/>
                <p:cNvSpPr/>
                <p:nvPr/>
              </p:nvSpPr>
              <p:spPr>
                <a:xfrm>
                  <a:off x="5643360" y="3925800"/>
                  <a:ext cx="717480" cy="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49" name="Group 237"/>
                <p:cNvGrpSpPr/>
                <p:nvPr/>
              </p:nvGrpSpPr>
              <p:grpSpPr>
                <a:xfrm>
                  <a:off x="2525400" y="3155760"/>
                  <a:ext cx="618480" cy="734760"/>
                  <a:chOff x="2525400" y="3155760"/>
                  <a:chExt cx="618480" cy="734760"/>
                </a:xfrm>
              </p:grpSpPr>
              <p:sp>
                <p:nvSpPr>
                  <p:cNvPr id="350" name="Oval 7"/>
                  <p:cNvSpPr/>
                  <p:nvPr/>
                </p:nvSpPr>
                <p:spPr>
                  <a:xfrm>
                    <a:off x="2709360" y="3155760"/>
                    <a:ext cx="56520" cy="5688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480" bIns="-64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1" name="Oval 8"/>
                  <p:cNvSpPr/>
                  <p:nvPr/>
                </p:nvSpPr>
                <p:spPr>
                  <a:xfrm>
                    <a:off x="2845800" y="3293640"/>
                    <a:ext cx="5832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2" name="Oval 9"/>
                  <p:cNvSpPr/>
                  <p:nvPr/>
                </p:nvSpPr>
                <p:spPr>
                  <a:xfrm>
                    <a:off x="2777400" y="3408120"/>
                    <a:ext cx="56880" cy="5688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480" bIns="-648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3" name="Oval 10"/>
                  <p:cNvSpPr/>
                  <p:nvPr/>
                </p:nvSpPr>
                <p:spPr>
                  <a:xfrm>
                    <a:off x="2869560" y="3166560"/>
                    <a:ext cx="56880" cy="590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5040" bIns="-504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4" name="Oval 11"/>
                  <p:cNvSpPr/>
                  <p:nvPr/>
                </p:nvSpPr>
                <p:spPr>
                  <a:xfrm>
                    <a:off x="2652120" y="3419280"/>
                    <a:ext cx="56880" cy="5868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5400" bIns="-54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5" name="Oval 12"/>
                  <p:cNvSpPr/>
                  <p:nvPr/>
                </p:nvSpPr>
                <p:spPr>
                  <a:xfrm>
                    <a:off x="3007800" y="3304800"/>
                    <a:ext cx="5688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6" name="Oval 13"/>
                  <p:cNvSpPr/>
                  <p:nvPr/>
                </p:nvSpPr>
                <p:spPr>
                  <a:xfrm>
                    <a:off x="2639520" y="3557160"/>
                    <a:ext cx="5832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7" name="Oval 14"/>
                  <p:cNvSpPr/>
                  <p:nvPr/>
                </p:nvSpPr>
                <p:spPr>
                  <a:xfrm>
                    <a:off x="2652120" y="3282480"/>
                    <a:ext cx="5688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8" name="Oval 15"/>
                  <p:cNvSpPr/>
                  <p:nvPr/>
                </p:nvSpPr>
                <p:spPr>
                  <a:xfrm>
                    <a:off x="3040920" y="3431880"/>
                    <a:ext cx="5688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9" name="Oval 16"/>
                  <p:cNvSpPr/>
                  <p:nvPr/>
                </p:nvSpPr>
                <p:spPr>
                  <a:xfrm>
                    <a:off x="2823480" y="3568320"/>
                    <a:ext cx="5688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0" name="Oval 17"/>
                  <p:cNvSpPr/>
                  <p:nvPr/>
                </p:nvSpPr>
                <p:spPr>
                  <a:xfrm>
                    <a:off x="2755440" y="3684240"/>
                    <a:ext cx="5652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1" name="Oval 18"/>
                  <p:cNvSpPr/>
                  <p:nvPr/>
                </p:nvSpPr>
                <p:spPr>
                  <a:xfrm>
                    <a:off x="3087000" y="3649320"/>
                    <a:ext cx="5688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2" name="Oval 19"/>
                  <p:cNvSpPr/>
                  <p:nvPr/>
                </p:nvSpPr>
                <p:spPr>
                  <a:xfrm>
                    <a:off x="2926800" y="3695400"/>
                    <a:ext cx="5688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3" name="Oval 20"/>
                  <p:cNvSpPr/>
                  <p:nvPr/>
                </p:nvSpPr>
                <p:spPr>
                  <a:xfrm>
                    <a:off x="2984040" y="3580920"/>
                    <a:ext cx="5652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4" name="Oval 21"/>
                  <p:cNvSpPr/>
                  <p:nvPr/>
                </p:nvSpPr>
                <p:spPr>
                  <a:xfrm>
                    <a:off x="2915640" y="3831840"/>
                    <a:ext cx="56880" cy="5868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5400" bIns="-540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5" name="Oval 22"/>
                  <p:cNvSpPr/>
                  <p:nvPr/>
                </p:nvSpPr>
                <p:spPr>
                  <a:xfrm>
                    <a:off x="2525400" y="3528720"/>
                    <a:ext cx="56880" cy="57240"/>
                  </a:xfrm>
                  <a:prstGeom prst="ellipse">
                    <a:avLst/>
                  </a:prstGeom>
                  <a:solidFill>
                    <a:srgbClr val="ffff00"/>
                  </a:solidFill>
                  <a:ln w="25560">
                    <a:solidFill>
                      <a:srgbClr val="6600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6120" bIns="-6120" anchor="ctr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</p:grpSp>
      <p:sp>
        <p:nvSpPr>
          <p:cNvPr id="366" name="Text Box 242"/>
          <p:cNvSpPr/>
          <p:nvPr/>
        </p:nvSpPr>
        <p:spPr>
          <a:xfrm>
            <a:off x="0" y="4608360"/>
            <a:ext cx="9144000" cy="210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3762360"/>
                <a:tab algn="l" pos="7524720"/>
              </a:tabLst>
            </a:pPr>
            <a:r>
              <a:rPr b="1" lang="en-US" sz="1100" spc="-1" strike="noStrike" u="sng">
                <a:solidFill>
                  <a:srgbClr val="053266"/>
                </a:solidFill>
                <a:uFillTx/>
                <a:latin typeface="Arial"/>
              </a:rPr>
              <a:t>Figure 2.</a:t>
            </a:r>
            <a:r>
              <a:rPr b="1" lang="en-US" sz="1100" spc="-1" strike="noStrike">
                <a:solidFill>
                  <a:srgbClr val="053266"/>
                </a:solidFill>
                <a:latin typeface="Arial"/>
              </a:rPr>
              <a:t> The Trofile Assay: Patient plasma virus is subjected to RT-PCR amplification to obtain a broad representation of envelope (env) genes from patient virus populations. </a:t>
            </a:r>
            <a:r>
              <a:rPr b="1" i="1" lang="en-US" sz="1100" spc="-1" strike="noStrike">
                <a:solidFill>
                  <a:srgbClr val="053266"/>
                </a:solidFill>
                <a:latin typeface="Arial"/>
              </a:rPr>
              <a:t>env</a:t>
            </a:r>
            <a:r>
              <a:rPr b="1" lang="en-US" sz="1100" spc="-1" strike="noStrike">
                <a:solidFill>
                  <a:srgbClr val="053266"/>
                </a:solidFill>
                <a:latin typeface="Arial"/>
              </a:rPr>
              <a:t> amplification products are then inserted into “HIV </a:t>
            </a:r>
            <a:r>
              <a:rPr b="1" i="1" lang="en-US" sz="1100" spc="-1" strike="noStrike">
                <a:solidFill>
                  <a:srgbClr val="053266"/>
                </a:solidFill>
                <a:latin typeface="Arial"/>
              </a:rPr>
              <a:t>env</a:t>
            </a:r>
            <a:r>
              <a:rPr b="1" lang="en-US" sz="1100" spc="-1" strike="noStrike">
                <a:solidFill>
                  <a:srgbClr val="053266"/>
                </a:solidFill>
                <a:latin typeface="Arial"/>
              </a:rPr>
              <a:t> expression vectors” (A).  Patient HIV </a:t>
            </a:r>
            <a:r>
              <a:rPr b="1" i="1" lang="en-US" sz="1100" spc="-1" strike="noStrike">
                <a:solidFill>
                  <a:srgbClr val="053266"/>
                </a:solidFill>
                <a:latin typeface="Arial"/>
              </a:rPr>
              <a:t>env</a:t>
            </a:r>
            <a:r>
              <a:rPr b="1" lang="en-US" sz="1100" spc="-1" strike="noStrike">
                <a:solidFill>
                  <a:srgbClr val="053266"/>
                </a:solidFill>
                <a:latin typeface="Arial"/>
              </a:rPr>
              <a:t> expression vectors are co-transfected with an env deleted “HIV genomic vector” (B) containing a firefly luciferase reporter gene that is used to quantify viral infectivity. Co-transfection of HIV </a:t>
            </a:r>
            <a:r>
              <a:rPr b="1" i="1" lang="en-US" sz="1100" spc="-1" strike="noStrike">
                <a:solidFill>
                  <a:srgbClr val="053266"/>
                </a:solidFill>
                <a:latin typeface="Arial"/>
              </a:rPr>
              <a:t>env</a:t>
            </a:r>
            <a:r>
              <a:rPr b="1" lang="en-US" sz="1100" spc="-1" strike="noStrike">
                <a:solidFill>
                  <a:srgbClr val="053266"/>
                </a:solidFill>
                <a:latin typeface="Arial"/>
              </a:rPr>
              <a:t> expression vectors and HIV genomic vectors produces HIV-1 pseudoviruses (C) expressing the </a:t>
            </a:r>
            <a:r>
              <a:rPr b="1" i="1" lang="en-US" sz="1100" spc="-1" strike="noStrike">
                <a:solidFill>
                  <a:srgbClr val="053266"/>
                </a:solidFill>
                <a:latin typeface="Arial"/>
              </a:rPr>
              <a:t>env </a:t>
            </a:r>
            <a:r>
              <a:rPr b="1" lang="en-US" sz="1100" spc="-1" strike="noStrike">
                <a:solidFill>
                  <a:srgbClr val="053266"/>
                </a:solidFill>
                <a:latin typeface="Arial"/>
              </a:rPr>
              <a:t>proteins derived from patient virus env sequences. Coreceptor tropism is determined by measuring the ability of pseudovirus populations to efficiently infect target cells co-expressing CD4 and CXCR4 (D) or CCR5 (E) co-receptors.  Co-receptor mediated infectivity is quantified by measuring luciferase infectivity in the CD4/CCR5 and CD4/CXCR4 target cells (portrayed as yellow asterisks).  In the diagram above, both CXCR4+ and CCR5+ cells are infected by pseudoviruses using patient </a:t>
            </a:r>
            <a:r>
              <a:rPr b="1" i="1" lang="en-US" sz="1100" spc="-1" strike="noStrike">
                <a:solidFill>
                  <a:srgbClr val="053266"/>
                </a:solidFill>
                <a:latin typeface="Arial"/>
              </a:rPr>
              <a:t>env</a:t>
            </a:r>
            <a:r>
              <a:rPr b="1" lang="en-US" sz="1100" spc="-1" strike="noStrike">
                <a:solidFill>
                  <a:srgbClr val="053266"/>
                </a:solidFill>
                <a:latin typeface="Arial"/>
              </a:rPr>
              <a:t> and, therefore, viral tropism would be classified as “R5/X4” or “dual/mixed”. To confirm co-receptor usage, CCR5 and CXCR4 entry inhibitors are added to target cells (F). Viruses susceptible to CCR5 and/or CXCR4 antagonists do not produce luciferase in the corresponding target cells.  Envelope genes encoding envelope proteins capable of using the CXCR4 co-receptor, the CCR5 co-receptor, or both co-receptors are shown in green, orange and blue, respectively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1-25T23:19:39Z</dcterms:created>
  <dc:creator>greg widmyer</dc:creator>
  <dc:description/>
  <dc:language>en-US</dc:language>
  <cp:lastModifiedBy>Registered User</cp:lastModifiedBy>
  <dcterms:modified xsi:type="dcterms:W3CDTF">2010-04-02T18:11:04Z</dcterms:modified>
  <cp:revision>492</cp:revision>
  <dc:subject/>
  <dc:title>Co-receptor Tropism  and the Next Generation  of Entry Inhibitors</dc:title>
</cp:coreProperties>
</file>